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4F5797-1D42-4781-8A3F-6E33B0A431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1D917-8381-46AE-BD9D-E60BF4F3E5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1C3B4-429F-4F44-90C7-85F461411F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88E16-8C8C-4E66-9852-AAC49A5BB4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0F3E3-565C-4269-B489-44746ED1B4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3C657-9872-4F37-8648-6432B048EE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08C9C-B21E-4C1C-BFAD-D0D6EC4295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A2E7D-2E3B-46E4-90E9-AB4BB1CDE7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5350D-CACD-4AA2-A578-61504C9028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6AE53-2D51-492D-B5FF-6FD8FB2206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2E6A8-3104-450D-9FC4-AF50525974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BA11E6-97CC-44D4-87B2-FF3AF81682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6ADBB6-B1B4-4226-8457-B0D8108C4D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0"/>
            <a:ext cx="6823080" cy="6461280"/>
            <a:chOff x="0" y="0"/>
            <a:chExt cx="6823080" cy="6461280"/>
          </a:xfrm>
        </p:grpSpPr>
        <p:sp>
          <p:nvSpPr>
            <p:cNvPr id="42" name=""/>
            <p:cNvSpPr/>
            <p:nvPr/>
          </p:nvSpPr>
          <p:spPr>
            <a:xfrm>
              <a:off x="1413000" y="54000"/>
              <a:ext cx="647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197000" y="2268360"/>
              <a:ext cx="1079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628640" y="4427640"/>
              <a:ext cx="28764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559160" y="4446720"/>
              <a:ext cx="46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869000" y="108000"/>
              <a:ext cx="647640" cy="142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724280" y="2268360"/>
              <a:ext cx="100980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084640" y="4427640"/>
              <a:ext cx="14472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009040" y="444168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T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04840" y="198756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04840" y="171936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04840" y="145080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04840" y="118908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04840" y="6541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04840" y="3859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04840" y="385920"/>
              <a:ext cx="3100320" cy="160164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04840" y="385920"/>
              <a:ext cx="1440" cy="1601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87200" y="19875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87200" y="17193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87200" y="14508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87200" y="118908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87200" y="922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87200" y="6541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87200" y="385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04840" y="9223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20484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148752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277020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3092400" y="921960"/>
              <a:ext cx="180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326556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330516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04840" y="922320"/>
              <a:ext cx="1336680" cy="623880"/>
            </a:xfrm>
            <a:custGeom>
              <a:avLst/>
              <a:gdLst/>
              <a:ahLst/>
              <a:rect l="l" t="t" r="r" b="b"/>
              <a:pathLst>
                <a:path w="1684" h="787">
                  <a:moveTo>
                    <a:pt x="0" y="0"/>
                  </a:moveTo>
                  <a:lnTo>
                    <a:pt x="105" y="50"/>
                  </a:lnTo>
                  <a:lnTo>
                    <a:pt x="210" y="106"/>
                  </a:lnTo>
                  <a:lnTo>
                    <a:pt x="427" y="232"/>
                  </a:lnTo>
                  <a:lnTo>
                    <a:pt x="638" y="359"/>
                  </a:lnTo>
                  <a:lnTo>
                    <a:pt x="853" y="478"/>
                  </a:lnTo>
                  <a:lnTo>
                    <a:pt x="1063" y="591"/>
                  </a:lnTo>
                  <a:lnTo>
                    <a:pt x="1168" y="639"/>
                  </a:lnTo>
                  <a:lnTo>
                    <a:pt x="1274" y="689"/>
                  </a:lnTo>
                  <a:lnTo>
                    <a:pt x="1379" y="726"/>
                  </a:lnTo>
                  <a:lnTo>
                    <a:pt x="1479" y="754"/>
                  </a:lnTo>
                  <a:lnTo>
                    <a:pt x="1584" y="774"/>
                  </a:lnTo>
                  <a:lnTo>
                    <a:pt x="1684" y="787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541520" y="1089000"/>
              <a:ext cx="1228680" cy="457200"/>
            </a:xfrm>
            <a:custGeom>
              <a:avLst/>
              <a:gdLst/>
              <a:ahLst/>
              <a:rect l="l" t="t" r="r" b="b"/>
              <a:pathLst>
                <a:path w="1548" h="576">
                  <a:moveTo>
                    <a:pt x="0" y="576"/>
                  </a:moveTo>
                  <a:lnTo>
                    <a:pt x="101" y="576"/>
                  </a:lnTo>
                  <a:lnTo>
                    <a:pt x="206" y="563"/>
                  </a:lnTo>
                  <a:lnTo>
                    <a:pt x="316" y="534"/>
                  </a:lnTo>
                  <a:lnTo>
                    <a:pt x="421" y="491"/>
                  </a:lnTo>
                  <a:lnTo>
                    <a:pt x="533" y="442"/>
                  </a:lnTo>
                  <a:lnTo>
                    <a:pt x="644" y="394"/>
                  </a:lnTo>
                  <a:lnTo>
                    <a:pt x="855" y="280"/>
                  </a:lnTo>
                  <a:lnTo>
                    <a:pt x="958" y="219"/>
                  </a:lnTo>
                  <a:lnTo>
                    <a:pt x="1059" y="163"/>
                  </a:lnTo>
                  <a:lnTo>
                    <a:pt x="1153" y="113"/>
                  </a:lnTo>
                  <a:lnTo>
                    <a:pt x="1242" y="71"/>
                  </a:lnTo>
                  <a:lnTo>
                    <a:pt x="1333" y="35"/>
                  </a:lnTo>
                  <a:lnTo>
                    <a:pt x="1412" y="6"/>
                  </a:lnTo>
                  <a:lnTo>
                    <a:pt x="1485" y="0"/>
                  </a:lnTo>
                  <a:lnTo>
                    <a:pt x="1548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70200" y="1089000"/>
              <a:ext cx="322200" cy="754200"/>
            </a:xfrm>
            <a:custGeom>
              <a:avLst/>
              <a:gdLst/>
              <a:ahLst/>
              <a:rect l="l" t="t" r="r" b="b"/>
              <a:pathLst>
                <a:path w="405" h="950">
                  <a:moveTo>
                    <a:pt x="0" y="0"/>
                  </a:moveTo>
                  <a:lnTo>
                    <a:pt x="58" y="21"/>
                  </a:lnTo>
                  <a:lnTo>
                    <a:pt x="106" y="56"/>
                  </a:lnTo>
                  <a:lnTo>
                    <a:pt x="148" y="98"/>
                  </a:lnTo>
                  <a:lnTo>
                    <a:pt x="185" y="154"/>
                  </a:lnTo>
                  <a:lnTo>
                    <a:pt x="217" y="219"/>
                  </a:lnTo>
                  <a:lnTo>
                    <a:pt x="243" y="294"/>
                  </a:lnTo>
                  <a:lnTo>
                    <a:pt x="269" y="367"/>
                  </a:lnTo>
                  <a:lnTo>
                    <a:pt x="290" y="451"/>
                  </a:lnTo>
                  <a:lnTo>
                    <a:pt x="322" y="605"/>
                  </a:lnTo>
                  <a:lnTo>
                    <a:pt x="332" y="681"/>
                  </a:lnTo>
                  <a:lnTo>
                    <a:pt x="349" y="752"/>
                  </a:lnTo>
                  <a:lnTo>
                    <a:pt x="359" y="816"/>
                  </a:lnTo>
                  <a:lnTo>
                    <a:pt x="373" y="871"/>
                  </a:lnTo>
                  <a:lnTo>
                    <a:pt x="391" y="914"/>
                  </a:lnTo>
                  <a:lnTo>
                    <a:pt x="405" y="95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092400" y="1719360"/>
              <a:ext cx="158760" cy="145800"/>
            </a:xfrm>
            <a:custGeom>
              <a:avLst/>
              <a:gdLst/>
              <a:ahLst/>
              <a:rect l="l" t="t" r="r" b="b"/>
              <a:pathLst>
                <a:path w="201" h="184">
                  <a:moveTo>
                    <a:pt x="0" y="155"/>
                  </a:moveTo>
                  <a:lnTo>
                    <a:pt x="17" y="169"/>
                  </a:lnTo>
                  <a:lnTo>
                    <a:pt x="33" y="184"/>
                  </a:lnTo>
                  <a:lnTo>
                    <a:pt x="43" y="184"/>
                  </a:lnTo>
                  <a:lnTo>
                    <a:pt x="59" y="184"/>
                  </a:lnTo>
                  <a:lnTo>
                    <a:pt x="86" y="161"/>
                  </a:lnTo>
                  <a:lnTo>
                    <a:pt x="111" y="134"/>
                  </a:lnTo>
                  <a:lnTo>
                    <a:pt x="138" y="100"/>
                  </a:lnTo>
                  <a:lnTo>
                    <a:pt x="159" y="57"/>
                  </a:lnTo>
                  <a:lnTo>
                    <a:pt x="179" y="21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770200" y="623880"/>
              <a:ext cx="322200" cy="465120"/>
            </a:xfrm>
            <a:custGeom>
              <a:avLst/>
              <a:gdLst/>
              <a:ahLst/>
              <a:rect l="l" t="t" r="r" b="b"/>
              <a:pathLst>
                <a:path w="405" h="585">
                  <a:moveTo>
                    <a:pt x="0" y="585"/>
                  </a:moveTo>
                  <a:lnTo>
                    <a:pt x="53" y="508"/>
                  </a:lnTo>
                  <a:lnTo>
                    <a:pt x="106" y="430"/>
                  </a:lnTo>
                  <a:lnTo>
                    <a:pt x="217" y="269"/>
                  </a:lnTo>
                  <a:lnTo>
                    <a:pt x="269" y="190"/>
                  </a:lnTo>
                  <a:lnTo>
                    <a:pt x="322" y="121"/>
                  </a:lnTo>
                  <a:lnTo>
                    <a:pt x="363" y="50"/>
                  </a:lnTo>
                  <a:lnTo>
                    <a:pt x="405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092400" y="496800"/>
              <a:ext cx="158760" cy="127080"/>
            </a:xfrm>
            <a:custGeom>
              <a:avLst/>
              <a:gdLst/>
              <a:ahLst/>
              <a:rect l="l" t="t" r="r" b="b"/>
              <a:pathLst>
                <a:path w="201" h="161">
                  <a:moveTo>
                    <a:pt x="0" y="161"/>
                  </a:moveTo>
                  <a:lnTo>
                    <a:pt x="33" y="126"/>
                  </a:lnTo>
                  <a:lnTo>
                    <a:pt x="59" y="99"/>
                  </a:lnTo>
                  <a:lnTo>
                    <a:pt x="86" y="76"/>
                  </a:lnTo>
                  <a:lnTo>
                    <a:pt x="111" y="57"/>
                  </a:lnTo>
                  <a:lnTo>
                    <a:pt x="159" y="27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455120" y="98280"/>
              <a:ext cx="22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ux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648440" y="98280"/>
              <a:ext cx="464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esponsiv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0920" y="1947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90000" y="1947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0920" y="168120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90000" y="16812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70920" y="141300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90000" y="1413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0920" y="11523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90000" y="11523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34640" y="882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7120" y="614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87120" y="345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76040" y="988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459080" y="988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72880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05100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22596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04840" y="385920"/>
              <a:ext cx="1440" cy="1601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87200" y="19875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87200" y="17193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87200" y="14508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87200" y="118908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87200" y="922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87200" y="6541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87200" y="385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04840" y="9223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0484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148752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277020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3092400" y="921960"/>
              <a:ext cx="180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3265560" y="921960"/>
              <a:ext cx="1440" cy="205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04840" y="922320"/>
              <a:ext cx="1336680" cy="623880"/>
            </a:xfrm>
            <a:custGeom>
              <a:avLst/>
              <a:gdLst/>
              <a:ahLst/>
              <a:rect l="l" t="t" r="r" b="b"/>
              <a:pathLst>
                <a:path w="1684" h="787">
                  <a:moveTo>
                    <a:pt x="0" y="0"/>
                  </a:moveTo>
                  <a:lnTo>
                    <a:pt x="105" y="50"/>
                  </a:lnTo>
                  <a:lnTo>
                    <a:pt x="210" y="106"/>
                  </a:lnTo>
                  <a:lnTo>
                    <a:pt x="427" y="232"/>
                  </a:lnTo>
                  <a:lnTo>
                    <a:pt x="638" y="359"/>
                  </a:lnTo>
                  <a:lnTo>
                    <a:pt x="853" y="478"/>
                  </a:lnTo>
                  <a:lnTo>
                    <a:pt x="1063" y="591"/>
                  </a:lnTo>
                  <a:lnTo>
                    <a:pt x="1168" y="639"/>
                  </a:lnTo>
                  <a:lnTo>
                    <a:pt x="1274" y="689"/>
                  </a:lnTo>
                  <a:lnTo>
                    <a:pt x="1379" y="726"/>
                  </a:lnTo>
                  <a:lnTo>
                    <a:pt x="1479" y="754"/>
                  </a:lnTo>
                  <a:lnTo>
                    <a:pt x="1584" y="774"/>
                  </a:lnTo>
                  <a:lnTo>
                    <a:pt x="1684" y="787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541520" y="1089000"/>
              <a:ext cx="1228680" cy="457200"/>
            </a:xfrm>
            <a:custGeom>
              <a:avLst/>
              <a:gdLst/>
              <a:ahLst/>
              <a:rect l="l" t="t" r="r" b="b"/>
              <a:pathLst>
                <a:path w="1548" h="576">
                  <a:moveTo>
                    <a:pt x="0" y="576"/>
                  </a:moveTo>
                  <a:lnTo>
                    <a:pt x="101" y="576"/>
                  </a:lnTo>
                  <a:lnTo>
                    <a:pt x="206" y="563"/>
                  </a:lnTo>
                  <a:lnTo>
                    <a:pt x="316" y="534"/>
                  </a:lnTo>
                  <a:lnTo>
                    <a:pt x="421" y="491"/>
                  </a:lnTo>
                  <a:lnTo>
                    <a:pt x="533" y="442"/>
                  </a:lnTo>
                  <a:lnTo>
                    <a:pt x="644" y="394"/>
                  </a:lnTo>
                  <a:lnTo>
                    <a:pt x="855" y="280"/>
                  </a:lnTo>
                  <a:lnTo>
                    <a:pt x="958" y="219"/>
                  </a:lnTo>
                  <a:lnTo>
                    <a:pt x="1059" y="163"/>
                  </a:lnTo>
                  <a:lnTo>
                    <a:pt x="1153" y="113"/>
                  </a:lnTo>
                  <a:lnTo>
                    <a:pt x="1242" y="71"/>
                  </a:lnTo>
                  <a:lnTo>
                    <a:pt x="1333" y="35"/>
                  </a:lnTo>
                  <a:lnTo>
                    <a:pt x="1412" y="6"/>
                  </a:lnTo>
                  <a:lnTo>
                    <a:pt x="1485" y="0"/>
                  </a:lnTo>
                  <a:lnTo>
                    <a:pt x="1548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770200" y="1089000"/>
              <a:ext cx="322200" cy="754200"/>
            </a:xfrm>
            <a:custGeom>
              <a:avLst/>
              <a:gdLst/>
              <a:ahLst/>
              <a:rect l="l" t="t" r="r" b="b"/>
              <a:pathLst>
                <a:path w="405" h="950">
                  <a:moveTo>
                    <a:pt x="0" y="0"/>
                  </a:moveTo>
                  <a:lnTo>
                    <a:pt x="58" y="21"/>
                  </a:lnTo>
                  <a:lnTo>
                    <a:pt x="106" y="56"/>
                  </a:lnTo>
                  <a:lnTo>
                    <a:pt x="148" y="98"/>
                  </a:lnTo>
                  <a:lnTo>
                    <a:pt x="185" y="154"/>
                  </a:lnTo>
                  <a:lnTo>
                    <a:pt x="217" y="219"/>
                  </a:lnTo>
                  <a:lnTo>
                    <a:pt x="243" y="294"/>
                  </a:lnTo>
                  <a:lnTo>
                    <a:pt x="269" y="367"/>
                  </a:lnTo>
                  <a:lnTo>
                    <a:pt x="290" y="451"/>
                  </a:lnTo>
                  <a:lnTo>
                    <a:pt x="322" y="605"/>
                  </a:lnTo>
                  <a:lnTo>
                    <a:pt x="332" y="681"/>
                  </a:lnTo>
                  <a:lnTo>
                    <a:pt x="349" y="752"/>
                  </a:lnTo>
                  <a:lnTo>
                    <a:pt x="359" y="816"/>
                  </a:lnTo>
                  <a:lnTo>
                    <a:pt x="373" y="871"/>
                  </a:lnTo>
                  <a:lnTo>
                    <a:pt x="391" y="914"/>
                  </a:lnTo>
                  <a:lnTo>
                    <a:pt x="405" y="95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092400" y="1719360"/>
              <a:ext cx="158760" cy="145800"/>
            </a:xfrm>
            <a:custGeom>
              <a:avLst/>
              <a:gdLst/>
              <a:ahLst/>
              <a:rect l="l" t="t" r="r" b="b"/>
              <a:pathLst>
                <a:path w="201" h="184">
                  <a:moveTo>
                    <a:pt x="0" y="155"/>
                  </a:moveTo>
                  <a:lnTo>
                    <a:pt x="17" y="169"/>
                  </a:lnTo>
                  <a:lnTo>
                    <a:pt x="33" y="184"/>
                  </a:lnTo>
                  <a:lnTo>
                    <a:pt x="43" y="184"/>
                  </a:lnTo>
                  <a:lnTo>
                    <a:pt x="59" y="184"/>
                  </a:lnTo>
                  <a:lnTo>
                    <a:pt x="86" y="161"/>
                  </a:lnTo>
                  <a:lnTo>
                    <a:pt x="111" y="134"/>
                  </a:lnTo>
                  <a:lnTo>
                    <a:pt x="138" y="100"/>
                  </a:lnTo>
                  <a:lnTo>
                    <a:pt x="159" y="57"/>
                  </a:lnTo>
                  <a:lnTo>
                    <a:pt x="179" y="21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770200" y="623880"/>
              <a:ext cx="322200" cy="465120"/>
            </a:xfrm>
            <a:custGeom>
              <a:avLst/>
              <a:gdLst/>
              <a:ahLst/>
              <a:rect l="l" t="t" r="r" b="b"/>
              <a:pathLst>
                <a:path w="405" h="585">
                  <a:moveTo>
                    <a:pt x="0" y="585"/>
                  </a:moveTo>
                  <a:lnTo>
                    <a:pt x="53" y="508"/>
                  </a:lnTo>
                  <a:lnTo>
                    <a:pt x="106" y="430"/>
                  </a:lnTo>
                  <a:lnTo>
                    <a:pt x="217" y="269"/>
                  </a:lnTo>
                  <a:lnTo>
                    <a:pt x="269" y="190"/>
                  </a:lnTo>
                  <a:lnTo>
                    <a:pt x="322" y="121"/>
                  </a:lnTo>
                  <a:lnTo>
                    <a:pt x="363" y="50"/>
                  </a:lnTo>
                  <a:lnTo>
                    <a:pt x="405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092400" y="496800"/>
              <a:ext cx="158760" cy="127080"/>
            </a:xfrm>
            <a:custGeom>
              <a:avLst/>
              <a:gdLst/>
              <a:ahLst/>
              <a:rect l="l" t="t" r="r" b="b"/>
              <a:pathLst>
                <a:path w="201" h="161">
                  <a:moveTo>
                    <a:pt x="0" y="161"/>
                  </a:moveTo>
                  <a:lnTo>
                    <a:pt x="33" y="126"/>
                  </a:lnTo>
                  <a:lnTo>
                    <a:pt x="59" y="99"/>
                  </a:lnTo>
                  <a:lnTo>
                    <a:pt x="86" y="76"/>
                  </a:lnTo>
                  <a:lnTo>
                    <a:pt x="111" y="57"/>
                  </a:lnTo>
                  <a:lnTo>
                    <a:pt x="159" y="27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1840" y="19479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1840" y="16812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1840" y="14130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840" y="11523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34640" y="882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74160" y="614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4160" y="345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76040" y="988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459080" y="9889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72880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05100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225960" y="9889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0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126440" y="79200"/>
              <a:ext cx="1213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uxin responsiv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0520" y="222264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0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87200" y="3903840"/>
              <a:ext cx="311796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87200" y="3741840"/>
              <a:ext cx="3117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87200" y="3575160"/>
              <a:ext cx="3117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87200" y="3406680"/>
              <a:ext cx="3117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87200" y="3244680"/>
              <a:ext cx="3117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87200" y="3078000"/>
              <a:ext cx="3117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87200" y="2909880"/>
              <a:ext cx="3117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87200" y="2747880"/>
              <a:ext cx="3117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87200" y="2581200"/>
              <a:ext cx="3117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87200" y="2581200"/>
              <a:ext cx="3117960" cy="149076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87200" y="2581200"/>
              <a:ext cx="1800" cy="149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71360" y="40719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71360" y="3903840"/>
              <a:ext cx="1584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71360" y="374184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71360" y="35751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71360" y="34066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71360" y="32446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71360" y="30780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71360" y="290988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71360" y="27478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71360" y="25812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87200" y="4071960"/>
              <a:ext cx="3117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18720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1479600" y="407196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276696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309240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flipV="1">
              <a:off x="3265560" y="407196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3305160" y="407196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187200" y="3708360"/>
              <a:ext cx="1346400" cy="363600"/>
            </a:xfrm>
            <a:custGeom>
              <a:avLst/>
              <a:gdLst/>
              <a:ahLst/>
              <a:rect l="l" t="t" r="r" b="b"/>
              <a:pathLst>
                <a:path w="1696" h="458">
                  <a:moveTo>
                    <a:pt x="0" y="458"/>
                  </a:moveTo>
                  <a:lnTo>
                    <a:pt x="212" y="395"/>
                  </a:lnTo>
                  <a:lnTo>
                    <a:pt x="428" y="332"/>
                  </a:lnTo>
                  <a:lnTo>
                    <a:pt x="859" y="197"/>
                  </a:lnTo>
                  <a:lnTo>
                    <a:pt x="1070" y="134"/>
                  </a:lnTo>
                  <a:lnTo>
                    <a:pt x="1281" y="78"/>
                  </a:lnTo>
                  <a:lnTo>
                    <a:pt x="1492" y="29"/>
                  </a:lnTo>
                  <a:lnTo>
                    <a:pt x="1696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1533600" y="3703680"/>
              <a:ext cx="1233360" cy="139680"/>
            </a:xfrm>
            <a:custGeom>
              <a:avLst/>
              <a:gdLst/>
              <a:ahLst/>
              <a:rect l="l" t="t" r="r" b="b"/>
              <a:pathLst>
                <a:path w="1555" h="177">
                  <a:moveTo>
                    <a:pt x="0" y="6"/>
                  </a:moveTo>
                  <a:lnTo>
                    <a:pt x="106" y="0"/>
                  </a:lnTo>
                  <a:lnTo>
                    <a:pt x="211" y="0"/>
                  </a:lnTo>
                  <a:lnTo>
                    <a:pt x="316" y="15"/>
                  </a:lnTo>
                  <a:lnTo>
                    <a:pt x="426" y="29"/>
                  </a:lnTo>
                  <a:lnTo>
                    <a:pt x="643" y="71"/>
                  </a:lnTo>
                  <a:lnTo>
                    <a:pt x="859" y="113"/>
                  </a:lnTo>
                  <a:lnTo>
                    <a:pt x="959" y="134"/>
                  </a:lnTo>
                  <a:lnTo>
                    <a:pt x="1060" y="153"/>
                  </a:lnTo>
                  <a:lnTo>
                    <a:pt x="1160" y="163"/>
                  </a:lnTo>
                  <a:lnTo>
                    <a:pt x="1249" y="177"/>
                  </a:lnTo>
                  <a:lnTo>
                    <a:pt x="1338" y="169"/>
                  </a:lnTo>
                  <a:lnTo>
                    <a:pt x="1417" y="163"/>
                  </a:lnTo>
                  <a:lnTo>
                    <a:pt x="1492" y="140"/>
                  </a:lnTo>
                  <a:lnTo>
                    <a:pt x="1555" y="11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766960" y="2752560"/>
              <a:ext cx="325440" cy="1041480"/>
            </a:xfrm>
            <a:custGeom>
              <a:avLst/>
              <a:gdLst/>
              <a:ahLst/>
              <a:rect l="l" t="t" r="r" b="b"/>
              <a:pathLst>
                <a:path w="409" h="1311">
                  <a:moveTo>
                    <a:pt x="0" y="1311"/>
                  </a:moveTo>
                  <a:lnTo>
                    <a:pt x="57" y="1269"/>
                  </a:lnTo>
                  <a:lnTo>
                    <a:pt x="105" y="1204"/>
                  </a:lnTo>
                  <a:lnTo>
                    <a:pt x="152" y="1135"/>
                  </a:lnTo>
                  <a:lnTo>
                    <a:pt x="189" y="1050"/>
                  </a:lnTo>
                  <a:lnTo>
                    <a:pt x="221" y="958"/>
                  </a:lnTo>
                  <a:lnTo>
                    <a:pt x="247" y="866"/>
                  </a:lnTo>
                  <a:lnTo>
                    <a:pt x="267" y="760"/>
                  </a:lnTo>
                  <a:lnTo>
                    <a:pt x="288" y="663"/>
                  </a:lnTo>
                  <a:lnTo>
                    <a:pt x="321" y="459"/>
                  </a:lnTo>
                  <a:lnTo>
                    <a:pt x="336" y="361"/>
                  </a:lnTo>
                  <a:lnTo>
                    <a:pt x="346" y="269"/>
                  </a:lnTo>
                  <a:lnTo>
                    <a:pt x="363" y="185"/>
                  </a:lnTo>
                  <a:lnTo>
                    <a:pt x="377" y="114"/>
                  </a:lnTo>
                  <a:lnTo>
                    <a:pt x="395" y="50"/>
                  </a:lnTo>
                  <a:lnTo>
                    <a:pt x="40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092400" y="2719440"/>
              <a:ext cx="158760" cy="52200"/>
            </a:xfrm>
            <a:custGeom>
              <a:avLst/>
              <a:gdLst/>
              <a:ahLst/>
              <a:rect l="l" t="t" r="r" b="b"/>
              <a:pathLst>
                <a:path w="201" h="65">
                  <a:moveTo>
                    <a:pt x="0" y="42"/>
                  </a:moveTo>
                  <a:lnTo>
                    <a:pt x="10" y="23"/>
                  </a:lnTo>
                  <a:lnTo>
                    <a:pt x="23" y="8"/>
                  </a:lnTo>
                  <a:lnTo>
                    <a:pt x="47" y="0"/>
                  </a:lnTo>
                  <a:lnTo>
                    <a:pt x="79" y="0"/>
                  </a:lnTo>
                  <a:lnTo>
                    <a:pt x="106" y="8"/>
                  </a:lnTo>
                  <a:lnTo>
                    <a:pt x="138" y="29"/>
                  </a:lnTo>
                  <a:lnTo>
                    <a:pt x="165" y="42"/>
                  </a:lnTo>
                  <a:lnTo>
                    <a:pt x="185" y="58"/>
                  </a:lnTo>
                  <a:lnTo>
                    <a:pt x="201" y="65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766960" y="3335400"/>
              <a:ext cx="325440" cy="458640"/>
            </a:xfrm>
            <a:custGeom>
              <a:avLst/>
              <a:gdLst/>
              <a:ahLst/>
              <a:rect l="l" t="t" r="r" b="b"/>
              <a:pathLst>
                <a:path w="409" h="577">
                  <a:moveTo>
                    <a:pt x="0" y="577"/>
                  </a:moveTo>
                  <a:lnTo>
                    <a:pt x="52" y="499"/>
                  </a:lnTo>
                  <a:lnTo>
                    <a:pt x="105" y="422"/>
                  </a:lnTo>
                  <a:lnTo>
                    <a:pt x="221" y="261"/>
                  </a:lnTo>
                  <a:lnTo>
                    <a:pt x="273" y="182"/>
                  </a:lnTo>
                  <a:lnTo>
                    <a:pt x="321" y="113"/>
                  </a:lnTo>
                  <a:lnTo>
                    <a:pt x="367" y="49"/>
                  </a:lnTo>
                  <a:lnTo>
                    <a:pt x="409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092400" y="3216240"/>
              <a:ext cx="158760" cy="119160"/>
            </a:xfrm>
            <a:custGeom>
              <a:avLst/>
              <a:gdLst/>
              <a:ahLst/>
              <a:rect l="l" t="t" r="r" b="b"/>
              <a:pathLst>
                <a:path w="201" h="150">
                  <a:moveTo>
                    <a:pt x="0" y="150"/>
                  </a:moveTo>
                  <a:lnTo>
                    <a:pt x="33" y="115"/>
                  </a:lnTo>
                  <a:lnTo>
                    <a:pt x="59" y="86"/>
                  </a:lnTo>
                  <a:lnTo>
                    <a:pt x="86" y="73"/>
                  </a:lnTo>
                  <a:lnTo>
                    <a:pt x="111" y="50"/>
                  </a:lnTo>
                  <a:lnTo>
                    <a:pt x="159" y="29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263240" y="2293920"/>
              <a:ext cx="22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ux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459080" y="2293920"/>
              <a:ext cx="1026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growth promoter prote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117000" y="4033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70920" y="3865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70920" y="3703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70920" y="3538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70920" y="3368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70920" y="3206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70920" y="3038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70920" y="2871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70920" y="2709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70920" y="2541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58760" y="414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450800" y="414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72556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05100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22596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0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0" y="219564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0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187200" y="2581200"/>
              <a:ext cx="1800" cy="149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171360" y="40719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71360" y="3903840"/>
              <a:ext cx="1584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71360" y="374184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71360" y="35751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71360" y="34066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71360" y="32446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71360" y="30780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71360" y="290988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171360" y="274788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171360" y="25812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187200" y="4071960"/>
              <a:ext cx="3117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V="1">
              <a:off x="18720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1479600" y="407196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276696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3092400" y="407196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flipV="1">
              <a:off x="3265560" y="407196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187200" y="3708360"/>
              <a:ext cx="1346400" cy="363600"/>
            </a:xfrm>
            <a:custGeom>
              <a:avLst/>
              <a:gdLst/>
              <a:ahLst/>
              <a:rect l="l" t="t" r="r" b="b"/>
              <a:pathLst>
                <a:path w="1696" h="458">
                  <a:moveTo>
                    <a:pt x="0" y="458"/>
                  </a:moveTo>
                  <a:lnTo>
                    <a:pt x="212" y="395"/>
                  </a:lnTo>
                  <a:lnTo>
                    <a:pt x="428" y="332"/>
                  </a:lnTo>
                  <a:lnTo>
                    <a:pt x="859" y="197"/>
                  </a:lnTo>
                  <a:lnTo>
                    <a:pt x="1070" y="134"/>
                  </a:lnTo>
                  <a:lnTo>
                    <a:pt x="1281" y="78"/>
                  </a:lnTo>
                  <a:lnTo>
                    <a:pt x="1492" y="29"/>
                  </a:lnTo>
                  <a:lnTo>
                    <a:pt x="1696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533600" y="3703680"/>
              <a:ext cx="1233360" cy="139680"/>
            </a:xfrm>
            <a:custGeom>
              <a:avLst/>
              <a:gdLst/>
              <a:ahLst/>
              <a:rect l="l" t="t" r="r" b="b"/>
              <a:pathLst>
                <a:path w="1555" h="177">
                  <a:moveTo>
                    <a:pt x="0" y="6"/>
                  </a:moveTo>
                  <a:lnTo>
                    <a:pt x="106" y="0"/>
                  </a:lnTo>
                  <a:lnTo>
                    <a:pt x="211" y="0"/>
                  </a:lnTo>
                  <a:lnTo>
                    <a:pt x="316" y="15"/>
                  </a:lnTo>
                  <a:lnTo>
                    <a:pt x="426" y="29"/>
                  </a:lnTo>
                  <a:lnTo>
                    <a:pt x="643" y="71"/>
                  </a:lnTo>
                  <a:lnTo>
                    <a:pt x="859" y="113"/>
                  </a:lnTo>
                  <a:lnTo>
                    <a:pt x="959" y="134"/>
                  </a:lnTo>
                  <a:lnTo>
                    <a:pt x="1060" y="153"/>
                  </a:lnTo>
                  <a:lnTo>
                    <a:pt x="1160" y="163"/>
                  </a:lnTo>
                  <a:lnTo>
                    <a:pt x="1249" y="177"/>
                  </a:lnTo>
                  <a:lnTo>
                    <a:pt x="1338" y="169"/>
                  </a:lnTo>
                  <a:lnTo>
                    <a:pt x="1417" y="163"/>
                  </a:lnTo>
                  <a:lnTo>
                    <a:pt x="1492" y="140"/>
                  </a:lnTo>
                  <a:lnTo>
                    <a:pt x="1555" y="11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766960" y="2752560"/>
              <a:ext cx="325440" cy="1041480"/>
            </a:xfrm>
            <a:custGeom>
              <a:avLst/>
              <a:gdLst/>
              <a:ahLst/>
              <a:rect l="l" t="t" r="r" b="b"/>
              <a:pathLst>
                <a:path w="409" h="1311">
                  <a:moveTo>
                    <a:pt x="0" y="1311"/>
                  </a:moveTo>
                  <a:lnTo>
                    <a:pt x="57" y="1269"/>
                  </a:lnTo>
                  <a:lnTo>
                    <a:pt x="105" y="1204"/>
                  </a:lnTo>
                  <a:lnTo>
                    <a:pt x="152" y="1135"/>
                  </a:lnTo>
                  <a:lnTo>
                    <a:pt x="189" y="1050"/>
                  </a:lnTo>
                  <a:lnTo>
                    <a:pt x="221" y="958"/>
                  </a:lnTo>
                  <a:lnTo>
                    <a:pt x="247" y="866"/>
                  </a:lnTo>
                  <a:lnTo>
                    <a:pt x="267" y="760"/>
                  </a:lnTo>
                  <a:lnTo>
                    <a:pt x="288" y="663"/>
                  </a:lnTo>
                  <a:lnTo>
                    <a:pt x="321" y="459"/>
                  </a:lnTo>
                  <a:lnTo>
                    <a:pt x="336" y="361"/>
                  </a:lnTo>
                  <a:lnTo>
                    <a:pt x="346" y="269"/>
                  </a:lnTo>
                  <a:lnTo>
                    <a:pt x="363" y="185"/>
                  </a:lnTo>
                  <a:lnTo>
                    <a:pt x="377" y="114"/>
                  </a:lnTo>
                  <a:lnTo>
                    <a:pt x="395" y="50"/>
                  </a:lnTo>
                  <a:lnTo>
                    <a:pt x="40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092400" y="2719440"/>
              <a:ext cx="158760" cy="52200"/>
            </a:xfrm>
            <a:custGeom>
              <a:avLst/>
              <a:gdLst/>
              <a:ahLst/>
              <a:rect l="l" t="t" r="r" b="b"/>
              <a:pathLst>
                <a:path w="201" h="65">
                  <a:moveTo>
                    <a:pt x="0" y="42"/>
                  </a:moveTo>
                  <a:lnTo>
                    <a:pt x="10" y="23"/>
                  </a:lnTo>
                  <a:lnTo>
                    <a:pt x="23" y="8"/>
                  </a:lnTo>
                  <a:lnTo>
                    <a:pt x="47" y="0"/>
                  </a:lnTo>
                  <a:lnTo>
                    <a:pt x="79" y="0"/>
                  </a:lnTo>
                  <a:lnTo>
                    <a:pt x="106" y="8"/>
                  </a:lnTo>
                  <a:lnTo>
                    <a:pt x="138" y="29"/>
                  </a:lnTo>
                  <a:lnTo>
                    <a:pt x="165" y="42"/>
                  </a:lnTo>
                  <a:lnTo>
                    <a:pt x="185" y="58"/>
                  </a:lnTo>
                  <a:lnTo>
                    <a:pt x="201" y="65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2766960" y="3335400"/>
              <a:ext cx="325440" cy="458640"/>
            </a:xfrm>
            <a:custGeom>
              <a:avLst/>
              <a:gdLst/>
              <a:ahLst/>
              <a:rect l="l" t="t" r="r" b="b"/>
              <a:pathLst>
                <a:path w="409" h="577">
                  <a:moveTo>
                    <a:pt x="0" y="577"/>
                  </a:moveTo>
                  <a:lnTo>
                    <a:pt x="52" y="499"/>
                  </a:lnTo>
                  <a:lnTo>
                    <a:pt x="105" y="422"/>
                  </a:lnTo>
                  <a:lnTo>
                    <a:pt x="221" y="261"/>
                  </a:lnTo>
                  <a:lnTo>
                    <a:pt x="273" y="182"/>
                  </a:lnTo>
                  <a:lnTo>
                    <a:pt x="321" y="113"/>
                  </a:lnTo>
                  <a:lnTo>
                    <a:pt x="367" y="49"/>
                  </a:lnTo>
                  <a:lnTo>
                    <a:pt x="409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3092400" y="3216240"/>
              <a:ext cx="158760" cy="119160"/>
            </a:xfrm>
            <a:custGeom>
              <a:avLst/>
              <a:gdLst/>
              <a:ahLst/>
              <a:rect l="l" t="t" r="r" b="b"/>
              <a:pathLst>
                <a:path w="201" h="150">
                  <a:moveTo>
                    <a:pt x="0" y="150"/>
                  </a:moveTo>
                  <a:lnTo>
                    <a:pt x="33" y="115"/>
                  </a:lnTo>
                  <a:lnTo>
                    <a:pt x="59" y="86"/>
                  </a:lnTo>
                  <a:lnTo>
                    <a:pt x="86" y="73"/>
                  </a:lnTo>
                  <a:lnTo>
                    <a:pt x="111" y="50"/>
                  </a:lnTo>
                  <a:lnTo>
                    <a:pt x="159" y="29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17000" y="4033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2200" y="3865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2200" y="3703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2200" y="3538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2200" y="3368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2200" y="3206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2200" y="3038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2200" y="2871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2200" y="2709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2200" y="2541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58760" y="414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450800" y="414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272556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305100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225960" y="414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20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785880" y="2292480"/>
              <a:ext cx="202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uxin growth promoter prote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158760" y="6342120"/>
              <a:ext cx="314640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158760" y="5884920"/>
              <a:ext cx="314640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158760" y="565632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158760" y="542772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158760" y="519912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158760" y="496872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58760" y="474012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158760" y="4740120"/>
              <a:ext cx="3146400" cy="160200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158760" y="4740120"/>
              <a:ext cx="1440" cy="1602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41120" y="63421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41120" y="61135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41120" y="58849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41120" y="5656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41120" y="5427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41120" y="51991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41120" y="49687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41120" y="47401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158760" y="6113520"/>
              <a:ext cx="314640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V="1">
              <a:off x="15876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flipV="1">
              <a:off x="1460520" y="6113520"/>
              <a:ext cx="32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flipV="1">
              <a:off x="276084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308772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V="1">
              <a:off x="3274920" y="6113520"/>
              <a:ext cx="180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330516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58760" y="6113520"/>
              <a:ext cx="1357200" cy="90360"/>
            </a:xfrm>
            <a:custGeom>
              <a:avLst/>
              <a:gdLst/>
              <a:ahLst/>
              <a:rect l="l" t="t" r="r" b="b"/>
              <a:pathLst>
                <a:path w="1709" h="113">
                  <a:moveTo>
                    <a:pt x="0" y="0"/>
                  </a:moveTo>
                  <a:lnTo>
                    <a:pt x="215" y="15"/>
                  </a:lnTo>
                  <a:lnTo>
                    <a:pt x="432" y="36"/>
                  </a:lnTo>
                  <a:lnTo>
                    <a:pt x="647" y="65"/>
                  </a:lnTo>
                  <a:lnTo>
                    <a:pt x="862" y="92"/>
                  </a:lnTo>
                  <a:lnTo>
                    <a:pt x="1079" y="113"/>
                  </a:lnTo>
                  <a:lnTo>
                    <a:pt x="1184" y="113"/>
                  </a:lnTo>
                  <a:lnTo>
                    <a:pt x="1295" y="113"/>
                  </a:lnTo>
                  <a:lnTo>
                    <a:pt x="1399" y="107"/>
                  </a:lnTo>
                  <a:lnTo>
                    <a:pt x="1506" y="92"/>
                  </a:lnTo>
                  <a:lnTo>
                    <a:pt x="1605" y="65"/>
                  </a:lnTo>
                  <a:lnTo>
                    <a:pt x="1709" y="36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515960" y="5214960"/>
              <a:ext cx="1244880" cy="928800"/>
            </a:xfrm>
            <a:custGeom>
              <a:avLst/>
              <a:gdLst/>
              <a:ahLst/>
              <a:rect l="l" t="t" r="r" b="b"/>
              <a:pathLst>
                <a:path w="1570" h="1169">
                  <a:moveTo>
                    <a:pt x="0" y="1169"/>
                  </a:moveTo>
                  <a:lnTo>
                    <a:pt x="105" y="1127"/>
                  </a:lnTo>
                  <a:lnTo>
                    <a:pt x="212" y="1077"/>
                  </a:lnTo>
                  <a:lnTo>
                    <a:pt x="322" y="1014"/>
                  </a:lnTo>
                  <a:lnTo>
                    <a:pt x="433" y="945"/>
                  </a:lnTo>
                  <a:lnTo>
                    <a:pt x="545" y="866"/>
                  </a:lnTo>
                  <a:lnTo>
                    <a:pt x="648" y="789"/>
                  </a:lnTo>
                  <a:lnTo>
                    <a:pt x="863" y="615"/>
                  </a:lnTo>
                  <a:lnTo>
                    <a:pt x="970" y="522"/>
                  </a:lnTo>
                  <a:lnTo>
                    <a:pt x="1074" y="438"/>
                  </a:lnTo>
                  <a:lnTo>
                    <a:pt x="1171" y="352"/>
                  </a:lnTo>
                  <a:lnTo>
                    <a:pt x="1265" y="267"/>
                  </a:lnTo>
                  <a:lnTo>
                    <a:pt x="1349" y="190"/>
                  </a:lnTo>
                  <a:lnTo>
                    <a:pt x="1428" y="119"/>
                  </a:lnTo>
                  <a:lnTo>
                    <a:pt x="1502" y="56"/>
                  </a:lnTo>
                  <a:lnTo>
                    <a:pt x="157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760840" y="4879800"/>
              <a:ext cx="326880" cy="335160"/>
            </a:xfrm>
            <a:custGeom>
              <a:avLst/>
              <a:gdLst/>
              <a:ahLst/>
              <a:rect l="l" t="t" r="r" b="b"/>
              <a:pathLst>
                <a:path w="412" h="422">
                  <a:moveTo>
                    <a:pt x="0" y="422"/>
                  </a:moveTo>
                  <a:lnTo>
                    <a:pt x="79" y="351"/>
                  </a:lnTo>
                  <a:lnTo>
                    <a:pt x="148" y="288"/>
                  </a:lnTo>
                  <a:lnTo>
                    <a:pt x="211" y="227"/>
                  </a:lnTo>
                  <a:lnTo>
                    <a:pt x="262" y="161"/>
                  </a:lnTo>
                  <a:lnTo>
                    <a:pt x="311" y="106"/>
                  </a:lnTo>
                  <a:lnTo>
                    <a:pt x="349" y="64"/>
                  </a:lnTo>
                  <a:lnTo>
                    <a:pt x="384" y="29"/>
                  </a:lnTo>
                  <a:lnTo>
                    <a:pt x="412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087720" y="4851360"/>
              <a:ext cx="162000" cy="28440"/>
            </a:xfrm>
            <a:custGeom>
              <a:avLst/>
              <a:gdLst/>
              <a:ahLst/>
              <a:rect l="l" t="t" r="r" b="b"/>
              <a:pathLst>
                <a:path w="204" h="36">
                  <a:moveTo>
                    <a:pt x="0" y="36"/>
                  </a:moveTo>
                  <a:lnTo>
                    <a:pt x="30" y="15"/>
                  </a:lnTo>
                  <a:lnTo>
                    <a:pt x="61" y="7"/>
                  </a:lnTo>
                  <a:lnTo>
                    <a:pt x="89" y="0"/>
                  </a:lnTo>
                  <a:lnTo>
                    <a:pt x="115" y="0"/>
                  </a:lnTo>
                  <a:lnTo>
                    <a:pt x="158" y="15"/>
                  </a:lnTo>
                  <a:lnTo>
                    <a:pt x="204" y="15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760840" y="5214960"/>
              <a:ext cx="326880" cy="698400"/>
            </a:xfrm>
            <a:custGeom>
              <a:avLst/>
              <a:gdLst/>
              <a:ahLst/>
              <a:rect l="l" t="t" r="r" b="b"/>
              <a:pathLst>
                <a:path w="412" h="879">
                  <a:moveTo>
                    <a:pt x="0" y="0"/>
                  </a:moveTo>
                  <a:lnTo>
                    <a:pt x="53" y="114"/>
                  </a:lnTo>
                  <a:lnTo>
                    <a:pt x="106" y="233"/>
                  </a:lnTo>
                  <a:lnTo>
                    <a:pt x="216" y="473"/>
                  </a:lnTo>
                  <a:lnTo>
                    <a:pt x="274" y="591"/>
                  </a:lnTo>
                  <a:lnTo>
                    <a:pt x="321" y="697"/>
                  </a:lnTo>
                  <a:lnTo>
                    <a:pt x="369" y="795"/>
                  </a:lnTo>
                  <a:lnTo>
                    <a:pt x="412" y="879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087720" y="5913360"/>
              <a:ext cx="162000" cy="257400"/>
            </a:xfrm>
            <a:custGeom>
              <a:avLst/>
              <a:gdLst/>
              <a:ahLst/>
              <a:rect l="l" t="t" r="r" b="b"/>
              <a:pathLst>
                <a:path w="204" h="325">
                  <a:moveTo>
                    <a:pt x="0" y="0"/>
                  </a:moveTo>
                  <a:lnTo>
                    <a:pt x="30" y="66"/>
                  </a:lnTo>
                  <a:lnTo>
                    <a:pt x="61" y="116"/>
                  </a:lnTo>
                  <a:lnTo>
                    <a:pt x="89" y="156"/>
                  </a:lnTo>
                  <a:lnTo>
                    <a:pt x="115" y="190"/>
                  </a:lnTo>
                  <a:lnTo>
                    <a:pt x="162" y="263"/>
                  </a:lnTo>
                  <a:lnTo>
                    <a:pt x="204" y="325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641240" y="4454640"/>
              <a:ext cx="19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CO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70920" y="6303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90000" y="6303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87120" y="6076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87120" y="5848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87120" y="5618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87120" y="5389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87120" y="51595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87120" y="49309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87120" y="47023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28520" y="6183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433520" y="6183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71944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04812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23388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158760" y="4740120"/>
              <a:ext cx="1440" cy="1602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141120" y="63421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141120" y="61135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141120" y="5884920"/>
              <a:ext cx="1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41120" y="5656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141120" y="5427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41120" y="51991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141120" y="49687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41120" y="47401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158760" y="6113520"/>
              <a:ext cx="314640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flipV="1">
              <a:off x="15876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flipV="1">
              <a:off x="1460520" y="6113520"/>
              <a:ext cx="32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V="1">
              <a:off x="276084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flipV="1">
              <a:off x="3087720" y="6113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 flipV="1">
              <a:off x="3274920" y="6113520"/>
              <a:ext cx="180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158760" y="6113520"/>
              <a:ext cx="1357200" cy="90360"/>
            </a:xfrm>
            <a:custGeom>
              <a:avLst/>
              <a:gdLst/>
              <a:ahLst/>
              <a:rect l="l" t="t" r="r" b="b"/>
              <a:pathLst>
                <a:path w="1709" h="113">
                  <a:moveTo>
                    <a:pt x="0" y="0"/>
                  </a:moveTo>
                  <a:lnTo>
                    <a:pt x="215" y="15"/>
                  </a:lnTo>
                  <a:lnTo>
                    <a:pt x="432" y="36"/>
                  </a:lnTo>
                  <a:lnTo>
                    <a:pt x="647" y="65"/>
                  </a:lnTo>
                  <a:lnTo>
                    <a:pt x="862" y="92"/>
                  </a:lnTo>
                  <a:lnTo>
                    <a:pt x="1079" y="113"/>
                  </a:lnTo>
                  <a:lnTo>
                    <a:pt x="1184" y="113"/>
                  </a:lnTo>
                  <a:lnTo>
                    <a:pt x="1295" y="113"/>
                  </a:lnTo>
                  <a:lnTo>
                    <a:pt x="1399" y="107"/>
                  </a:lnTo>
                  <a:lnTo>
                    <a:pt x="1506" y="92"/>
                  </a:lnTo>
                  <a:lnTo>
                    <a:pt x="1605" y="65"/>
                  </a:lnTo>
                  <a:lnTo>
                    <a:pt x="1709" y="36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515960" y="5214960"/>
              <a:ext cx="1244880" cy="928800"/>
            </a:xfrm>
            <a:custGeom>
              <a:avLst/>
              <a:gdLst/>
              <a:ahLst/>
              <a:rect l="l" t="t" r="r" b="b"/>
              <a:pathLst>
                <a:path w="1570" h="1169">
                  <a:moveTo>
                    <a:pt x="0" y="1169"/>
                  </a:moveTo>
                  <a:lnTo>
                    <a:pt x="105" y="1127"/>
                  </a:lnTo>
                  <a:lnTo>
                    <a:pt x="212" y="1077"/>
                  </a:lnTo>
                  <a:lnTo>
                    <a:pt x="322" y="1014"/>
                  </a:lnTo>
                  <a:lnTo>
                    <a:pt x="433" y="945"/>
                  </a:lnTo>
                  <a:lnTo>
                    <a:pt x="545" y="866"/>
                  </a:lnTo>
                  <a:lnTo>
                    <a:pt x="648" y="789"/>
                  </a:lnTo>
                  <a:lnTo>
                    <a:pt x="863" y="615"/>
                  </a:lnTo>
                  <a:lnTo>
                    <a:pt x="970" y="522"/>
                  </a:lnTo>
                  <a:lnTo>
                    <a:pt x="1074" y="438"/>
                  </a:lnTo>
                  <a:lnTo>
                    <a:pt x="1171" y="352"/>
                  </a:lnTo>
                  <a:lnTo>
                    <a:pt x="1265" y="267"/>
                  </a:lnTo>
                  <a:lnTo>
                    <a:pt x="1349" y="190"/>
                  </a:lnTo>
                  <a:lnTo>
                    <a:pt x="1428" y="119"/>
                  </a:lnTo>
                  <a:lnTo>
                    <a:pt x="1502" y="56"/>
                  </a:lnTo>
                  <a:lnTo>
                    <a:pt x="1570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760840" y="4879800"/>
              <a:ext cx="326880" cy="335160"/>
            </a:xfrm>
            <a:custGeom>
              <a:avLst/>
              <a:gdLst/>
              <a:ahLst/>
              <a:rect l="l" t="t" r="r" b="b"/>
              <a:pathLst>
                <a:path w="412" h="422">
                  <a:moveTo>
                    <a:pt x="0" y="422"/>
                  </a:moveTo>
                  <a:lnTo>
                    <a:pt x="79" y="351"/>
                  </a:lnTo>
                  <a:lnTo>
                    <a:pt x="148" y="288"/>
                  </a:lnTo>
                  <a:lnTo>
                    <a:pt x="211" y="227"/>
                  </a:lnTo>
                  <a:lnTo>
                    <a:pt x="262" y="161"/>
                  </a:lnTo>
                  <a:lnTo>
                    <a:pt x="311" y="106"/>
                  </a:lnTo>
                  <a:lnTo>
                    <a:pt x="349" y="64"/>
                  </a:lnTo>
                  <a:lnTo>
                    <a:pt x="384" y="29"/>
                  </a:lnTo>
                  <a:lnTo>
                    <a:pt x="412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3087720" y="4851360"/>
              <a:ext cx="162000" cy="28440"/>
            </a:xfrm>
            <a:custGeom>
              <a:avLst/>
              <a:gdLst/>
              <a:ahLst/>
              <a:rect l="l" t="t" r="r" b="b"/>
              <a:pathLst>
                <a:path w="204" h="36">
                  <a:moveTo>
                    <a:pt x="0" y="36"/>
                  </a:moveTo>
                  <a:lnTo>
                    <a:pt x="30" y="15"/>
                  </a:lnTo>
                  <a:lnTo>
                    <a:pt x="61" y="7"/>
                  </a:lnTo>
                  <a:lnTo>
                    <a:pt x="89" y="0"/>
                  </a:lnTo>
                  <a:lnTo>
                    <a:pt x="115" y="0"/>
                  </a:lnTo>
                  <a:lnTo>
                    <a:pt x="158" y="15"/>
                  </a:lnTo>
                  <a:lnTo>
                    <a:pt x="204" y="15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760840" y="5214960"/>
              <a:ext cx="326880" cy="698400"/>
            </a:xfrm>
            <a:custGeom>
              <a:avLst/>
              <a:gdLst/>
              <a:ahLst/>
              <a:rect l="l" t="t" r="r" b="b"/>
              <a:pathLst>
                <a:path w="412" h="879">
                  <a:moveTo>
                    <a:pt x="0" y="0"/>
                  </a:moveTo>
                  <a:lnTo>
                    <a:pt x="53" y="114"/>
                  </a:lnTo>
                  <a:lnTo>
                    <a:pt x="106" y="233"/>
                  </a:lnTo>
                  <a:lnTo>
                    <a:pt x="216" y="473"/>
                  </a:lnTo>
                  <a:lnTo>
                    <a:pt x="274" y="591"/>
                  </a:lnTo>
                  <a:lnTo>
                    <a:pt x="321" y="697"/>
                  </a:lnTo>
                  <a:lnTo>
                    <a:pt x="369" y="795"/>
                  </a:lnTo>
                  <a:lnTo>
                    <a:pt x="412" y="879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3087720" y="5913360"/>
              <a:ext cx="162000" cy="257400"/>
            </a:xfrm>
            <a:custGeom>
              <a:avLst/>
              <a:gdLst/>
              <a:ahLst/>
              <a:rect l="l" t="t" r="r" b="b"/>
              <a:pathLst>
                <a:path w="204" h="325">
                  <a:moveTo>
                    <a:pt x="0" y="0"/>
                  </a:moveTo>
                  <a:lnTo>
                    <a:pt x="30" y="66"/>
                  </a:lnTo>
                  <a:lnTo>
                    <a:pt x="61" y="116"/>
                  </a:lnTo>
                  <a:lnTo>
                    <a:pt x="89" y="156"/>
                  </a:lnTo>
                  <a:lnTo>
                    <a:pt x="115" y="190"/>
                  </a:lnTo>
                  <a:lnTo>
                    <a:pt x="162" y="263"/>
                  </a:lnTo>
                  <a:lnTo>
                    <a:pt x="204" y="325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1641600" y="4454640"/>
              <a:ext cx="28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C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70920" y="6303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90000" y="6303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87120" y="6076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87120" y="5848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87120" y="5618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87120" y="5389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87120" y="51595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87120" y="49309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87120" y="47023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128520" y="6183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433520" y="6183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271944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304812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3233880" y="6183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20520" y="4383000"/>
              <a:ext cx="337212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3449520" y="2700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3449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3633840" y="198756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3633840" y="18097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633840" y="163044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633840" y="145080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633840" y="12733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3633840" y="110160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633840" y="9223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3633840" y="74124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3633840" y="385920"/>
              <a:ext cx="3100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3633840" y="385920"/>
              <a:ext cx="3100320" cy="160164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3633840" y="385920"/>
              <a:ext cx="1440" cy="1601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3616200" y="19875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3616200" y="1809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3616200" y="16304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3616200" y="14508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3616200" y="1273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3616200" y="11016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3616200" y="922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3616200" y="74124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3616200" y="5634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3616200" y="385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3633840" y="56340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V="1">
              <a:off x="363384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V="1">
              <a:off x="491652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flipV="1">
              <a:off x="619920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6521400" y="56340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669456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 flipV="1">
              <a:off x="673416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3633840" y="557280"/>
              <a:ext cx="1336680" cy="19080"/>
            </a:xfrm>
            <a:custGeom>
              <a:avLst/>
              <a:gdLst/>
              <a:ahLst/>
              <a:rect l="l" t="t" r="r" b="b"/>
              <a:pathLst>
                <a:path w="1684" h="23">
                  <a:moveTo>
                    <a:pt x="0" y="8"/>
                  </a:moveTo>
                  <a:lnTo>
                    <a:pt x="427" y="8"/>
                  </a:lnTo>
                  <a:lnTo>
                    <a:pt x="853" y="0"/>
                  </a:lnTo>
                  <a:lnTo>
                    <a:pt x="1274" y="0"/>
                  </a:lnTo>
                  <a:lnTo>
                    <a:pt x="1479" y="8"/>
                  </a:lnTo>
                  <a:lnTo>
                    <a:pt x="1684" y="2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970520" y="576360"/>
              <a:ext cx="1228680" cy="176040"/>
            </a:xfrm>
            <a:custGeom>
              <a:avLst/>
              <a:gdLst/>
              <a:ahLst/>
              <a:rect l="l" t="t" r="r" b="b"/>
              <a:pathLst>
                <a:path w="1548" h="223">
                  <a:moveTo>
                    <a:pt x="0" y="0"/>
                  </a:moveTo>
                  <a:lnTo>
                    <a:pt x="206" y="6"/>
                  </a:lnTo>
                  <a:lnTo>
                    <a:pt x="421" y="14"/>
                  </a:lnTo>
                  <a:lnTo>
                    <a:pt x="644" y="14"/>
                  </a:lnTo>
                  <a:lnTo>
                    <a:pt x="855" y="27"/>
                  </a:lnTo>
                  <a:lnTo>
                    <a:pt x="958" y="33"/>
                  </a:lnTo>
                  <a:lnTo>
                    <a:pt x="1059" y="48"/>
                  </a:lnTo>
                  <a:lnTo>
                    <a:pt x="1153" y="62"/>
                  </a:lnTo>
                  <a:lnTo>
                    <a:pt x="1242" y="83"/>
                  </a:lnTo>
                  <a:lnTo>
                    <a:pt x="1333" y="104"/>
                  </a:lnTo>
                  <a:lnTo>
                    <a:pt x="1412" y="141"/>
                  </a:lnTo>
                  <a:lnTo>
                    <a:pt x="1485" y="175"/>
                  </a:lnTo>
                  <a:lnTo>
                    <a:pt x="1548" y="22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6199200" y="752400"/>
              <a:ext cx="322200" cy="1106640"/>
            </a:xfrm>
            <a:custGeom>
              <a:avLst/>
              <a:gdLst/>
              <a:ahLst/>
              <a:rect l="l" t="t" r="r" b="b"/>
              <a:pathLst>
                <a:path w="405" h="1393">
                  <a:moveTo>
                    <a:pt x="0" y="0"/>
                  </a:moveTo>
                  <a:lnTo>
                    <a:pt x="58" y="58"/>
                  </a:lnTo>
                  <a:lnTo>
                    <a:pt x="106" y="129"/>
                  </a:lnTo>
                  <a:lnTo>
                    <a:pt x="148" y="213"/>
                  </a:lnTo>
                  <a:lnTo>
                    <a:pt x="185" y="305"/>
                  </a:lnTo>
                  <a:lnTo>
                    <a:pt x="217" y="403"/>
                  </a:lnTo>
                  <a:lnTo>
                    <a:pt x="243" y="509"/>
                  </a:lnTo>
                  <a:lnTo>
                    <a:pt x="269" y="614"/>
                  </a:lnTo>
                  <a:lnTo>
                    <a:pt x="290" y="727"/>
                  </a:lnTo>
                  <a:lnTo>
                    <a:pt x="322" y="939"/>
                  </a:lnTo>
                  <a:lnTo>
                    <a:pt x="332" y="1036"/>
                  </a:lnTo>
                  <a:lnTo>
                    <a:pt x="349" y="1134"/>
                  </a:lnTo>
                  <a:lnTo>
                    <a:pt x="359" y="1219"/>
                  </a:lnTo>
                  <a:lnTo>
                    <a:pt x="373" y="1290"/>
                  </a:lnTo>
                  <a:lnTo>
                    <a:pt x="391" y="1353"/>
                  </a:lnTo>
                  <a:lnTo>
                    <a:pt x="405" y="139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6521400" y="1685880"/>
              <a:ext cx="158760" cy="201600"/>
            </a:xfrm>
            <a:custGeom>
              <a:avLst/>
              <a:gdLst/>
              <a:ahLst/>
              <a:rect l="l" t="t" r="r" b="b"/>
              <a:pathLst>
                <a:path w="201" h="254">
                  <a:moveTo>
                    <a:pt x="0" y="217"/>
                  </a:moveTo>
                  <a:lnTo>
                    <a:pt x="17" y="240"/>
                  </a:lnTo>
                  <a:lnTo>
                    <a:pt x="27" y="254"/>
                  </a:lnTo>
                  <a:lnTo>
                    <a:pt x="43" y="254"/>
                  </a:lnTo>
                  <a:lnTo>
                    <a:pt x="55" y="254"/>
                  </a:lnTo>
                  <a:lnTo>
                    <a:pt x="69" y="240"/>
                  </a:lnTo>
                  <a:lnTo>
                    <a:pt x="86" y="227"/>
                  </a:lnTo>
                  <a:lnTo>
                    <a:pt x="111" y="185"/>
                  </a:lnTo>
                  <a:lnTo>
                    <a:pt x="138" y="129"/>
                  </a:lnTo>
                  <a:lnTo>
                    <a:pt x="159" y="79"/>
                  </a:lnTo>
                  <a:lnTo>
                    <a:pt x="179" y="27"/>
                  </a:lnTo>
                  <a:lnTo>
                    <a:pt x="190" y="14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6199200" y="752400"/>
              <a:ext cx="322200" cy="1079640"/>
            </a:xfrm>
            <a:custGeom>
              <a:avLst/>
              <a:gdLst/>
              <a:ahLst/>
              <a:rect l="l" t="t" r="r" b="b"/>
              <a:pathLst>
                <a:path w="405" h="1361">
                  <a:moveTo>
                    <a:pt x="0" y="0"/>
                  </a:moveTo>
                  <a:lnTo>
                    <a:pt x="27" y="92"/>
                  </a:lnTo>
                  <a:lnTo>
                    <a:pt x="53" y="184"/>
                  </a:lnTo>
                  <a:lnTo>
                    <a:pt x="106" y="388"/>
                  </a:lnTo>
                  <a:lnTo>
                    <a:pt x="162" y="593"/>
                  </a:lnTo>
                  <a:lnTo>
                    <a:pt x="217" y="797"/>
                  </a:lnTo>
                  <a:lnTo>
                    <a:pt x="243" y="894"/>
                  </a:lnTo>
                  <a:lnTo>
                    <a:pt x="269" y="987"/>
                  </a:lnTo>
                  <a:lnTo>
                    <a:pt x="294" y="1073"/>
                  </a:lnTo>
                  <a:lnTo>
                    <a:pt x="322" y="1155"/>
                  </a:lnTo>
                  <a:lnTo>
                    <a:pt x="342" y="1219"/>
                  </a:lnTo>
                  <a:lnTo>
                    <a:pt x="363" y="1282"/>
                  </a:lnTo>
                  <a:lnTo>
                    <a:pt x="385" y="1324"/>
                  </a:lnTo>
                  <a:lnTo>
                    <a:pt x="405" y="136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6521400" y="1417680"/>
              <a:ext cx="158760" cy="436680"/>
            </a:xfrm>
            <a:custGeom>
              <a:avLst/>
              <a:gdLst/>
              <a:ahLst/>
              <a:rect l="l" t="t" r="r" b="b"/>
              <a:pathLst>
                <a:path w="201" h="549">
                  <a:moveTo>
                    <a:pt x="0" y="522"/>
                  </a:moveTo>
                  <a:lnTo>
                    <a:pt x="17" y="541"/>
                  </a:lnTo>
                  <a:lnTo>
                    <a:pt x="37" y="549"/>
                  </a:lnTo>
                  <a:lnTo>
                    <a:pt x="55" y="541"/>
                  </a:lnTo>
                  <a:lnTo>
                    <a:pt x="65" y="522"/>
                  </a:lnTo>
                  <a:lnTo>
                    <a:pt x="79" y="499"/>
                  </a:lnTo>
                  <a:lnTo>
                    <a:pt x="90" y="466"/>
                  </a:lnTo>
                  <a:lnTo>
                    <a:pt x="101" y="424"/>
                  </a:lnTo>
                  <a:lnTo>
                    <a:pt x="111" y="380"/>
                  </a:lnTo>
                  <a:lnTo>
                    <a:pt x="132" y="276"/>
                  </a:lnTo>
                  <a:lnTo>
                    <a:pt x="154" y="176"/>
                  </a:lnTo>
                  <a:lnTo>
                    <a:pt x="179" y="76"/>
                  </a:lnTo>
                  <a:lnTo>
                    <a:pt x="190" y="36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879800" y="98280"/>
              <a:ext cx="732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ethylene recepto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3499920" y="19479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3519000" y="1947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499920" y="17715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519000" y="1771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3499920" y="159228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519000" y="1592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499920" y="141300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519000" y="1413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499920" y="12351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519000" y="1235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499920" y="106056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519000" y="1060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499920" y="88272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3519000" y="882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3499920" y="70344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3519000" y="703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3563640" y="523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3516120" y="345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605040" y="63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4888080" y="63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615780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648000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665496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449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429000" y="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449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3633840" y="385920"/>
              <a:ext cx="1440" cy="1601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3616200" y="198756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3616200" y="1809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3616200" y="16304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3616200" y="14508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3616200" y="1273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3616200" y="11016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3616200" y="9223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3616200" y="74124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616200" y="56340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3616200" y="385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3633840" y="563400"/>
              <a:ext cx="3100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 flipV="1">
              <a:off x="363384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 flipV="1">
              <a:off x="491652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 flipV="1">
              <a:off x="619920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 flipV="1">
              <a:off x="6521400" y="563400"/>
              <a:ext cx="180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 flipV="1">
              <a:off x="6694560" y="563400"/>
              <a:ext cx="1440" cy="22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3633840" y="557280"/>
              <a:ext cx="1336680" cy="19080"/>
            </a:xfrm>
            <a:custGeom>
              <a:avLst/>
              <a:gdLst/>
              <a:ahLst/>
              <a:rect l="l" t="t" r="r" b="b"/>
              <a:pathLst>
                <a:path w="1684" h="23">
                  <a:moveTo>
                    <a:pt x="0" y="8"/>
                  </a:moveTo>
                  <a:lnTo>
                    <a:pt x="427" y="8"/>
                  </a:lnTo>
                  <a:lnTo>
                    <a:pt x="853" y="0"/>
                  </a:lnTo>
                  <a:lnTo>
                    <a:pt x="1274" y="0"/>
                  </a:lnTo>
                  <a:lnTo>
                    <a:pt x="1479" y="8"/>
                  </a:lnTo>
                  <a:lnTo>
                    <a:pt x="1684" y="2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970520" y="576360"/>
              <a:ext cx="1228680" cy="176040"/>
            </a:xfrm>
            <a:custGeom>
              <a:avLst/>
              <a:gdLst/>
              <a:ahLst/>
              <a:rect l="l" t="t" r="r" b="b"/>
              <a:pathLst>
                <a:path w="1548" h="223">
                  <a:moveTo>
                    <a:pt x="0" y="0"/>
                  </a:moveTo>
                  <a:lnTo>
                    <a:pt x="206" y="6"/>
                  </a:lnTo>
                  <a:lnTo>
                    <a:pt x="421" y="14"/>
                  </a:lnTo>
                  <a:lnTo>
                    <a:pt x="644" y="14"/>
                  </a:lnTo>
                  <a:lnTo>
                    <a:pt x="855" y="27"/>
                  </a:lnTo>
                  <a:lnTo>
                    <a:pt x="958" y="33"/>
                  </a:lnTo>
                  <a:lnTo>
                    <a:pt x="1059" y="48"/>
                  </a:lnTo>
                  <a:lnTo>
                    <a:pt x="1153" y="62"/>
                  </a:lnTo>
                  <a:lnTo>
                    <a:pt x="1242" y="83"/>
                  </a:lnTo>
                  <a:lnTo>
                    <a:pt x="1333" y="104"/>
                  </a:lnTo>
                  <a:lnTo>
                    <a:pt x="1412" y="141"/>
                  </a:lnTo>
                  <a:lnTo>
                    <a:pt x="1485" y="175"/>
                  </a:lnTo>
                  <a:lnTo>
                    <a:pt x="1548" y="22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6199200" y="752400"/>
              <a:ext cx="322200" cy="1106640"/>
            </a:xfrm>
            <a:custGeom>
              <a:avLst/>
              <a:gdLst/>
              <a:ahLst/>
              <a:rect l="l" t="t" r="r" b="b"/>
              <a:pathLst>
                <a:path w="405" h="1393">
                  <a:moveTo>
                    <a:pt x="0" y="0"/>
                  </a:moveTo>
                  <a:lnTo>
                    <a:pt x="58" y="58"/>
                  </a:lnTo>
                  <a:lnTo>
                    <a:pt x="106" y="129"/>
                  </a:lnTo>
                  <a:lnTo>
                    <a:pt x="148" y="213"/>
                  </a:lnTo>
                  <a:lnTo>
                    <a:pt x="185" y="305"/>
                  </a:lnTo>
                  <a:lnTo>
                    <a:pt x="217" y="403"/>
                  </a:lnTo>
                  <a:lnTo>
                    <a:pt x="243" y="509"/>
                  </a:lnTo>
                  <a:lnTo>
                    <a:pt x="269" y="614"/>
                  </a:lnTo>
                  <a:lnTo>
                    <a:pt x="290" y="727"/>
                  </a:lnTo>
                  <a:lnTo>
                    <a:pt x="322" y="939"/>
                  </a:lnTo>
                  <a:lnTo>
                    <a:pt x="332" y="1036"/>
                  </a:lnTo>
                  <a:lnTo>
                    <a:pt x="349" y="1134"/>
                  </a:lnTo>
                  <a:lnTo>
                    <a:pt x="359" y="1219"/>
                  </a:lnTo>
                  <a:lnTo>
                    <a:pt x="373" y="1290"/>
                  </a:lnTo>
                  <a:lnTo>
                    <a:pt x="391" y="1353"/>
                  </a:lnTo>
                  <a:lnTo>
                    <a:pt x="405" y="1393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6521400" y="1685880"/>
              <a:ext cx="158760" cy="201600"/>
            </a:xfrm>
            <a:custGeom>
              <a:avLst/>
              <a:gdLst/>
              <a:ahLst/>
              <a:rect l="l" t="t" r="r" b="b"/>
              <a:pathLst>
                <a:path w="201" h="254">
                  <a:moveTo>
                    <a:pt x="0" y="217"/>
                  </a:moveTo>
                  <a:lnTo>
                    <a:pt x="17" y="240"/>
                  </a:lnTo>
                  <a:lnTo>
                    <a:pt x="27" y="254"/>
                  </a:lnTo>
                  <a:lnTo>
                    <a:pt x="43" y="254"/>
                  </a:lnTo>
                  <a:lnTo>
                    <a:pt x="55" y="254"/>
                  </a:lnTo>
                  <a:lnTo>
                    <a:pt x="69" y="240"/>
                  </a:lnTo>
                  <a:lnTo>
                    <a:pt x="86" y="227"/>
                  </a:lnTo>
                  <a:lnTo>
                    <a:pt x="111" y="185"/>
                  </a:lnTo>
                  <a:lnTo>
                    <a:pt x="138" y="129"/>
                  </a:lnTo>
                  <a:lnTo>
                    <a:pt x="159" y="79"/>
                  </a:lnTo>
                  <a:lnTo>
                    <a:pt x="179" y="27"/>
                  </a:lnTo>
                  <a:lnTo>
                    <a:pt x="190" y="14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6199200" y="752400"/>
              <a:ext cx="322200" cy="1079640"/>
            </a:xfrm>
            <a:custGeom>
              <a:avLst/>
              <a:gdLst/>
              <a:ahLst/>
              <a:rect l="l" t="t" r="r" b="b"/>
              <a:pathLst>
                <a:path w="405" h="1361">
                  <a:moveTo>
                    <a:pt x="0" y="0"/>
                  </a:moveTo>
                  <a:lnTo>
                    <a:pt x="27" y="92"/>
                  </a:lnTo>
                  <a:lnTo>
                    <a:pt x="53" y="184"/>
                  </a:lnTo>
                  <a:lnTo>
                    <a:pt x="106" y="388"/>
                  </a:lnTo>
                  <a:lnTo>
                    <a:pt x="162" y="593"/>
                  </a:lnTo>
                  <a:lnTo>
                    <a:pt x="217" y="797"/>
                  </a:lnTo>
                  <a:lnTo>
                    <a:pt x="243" y="894"/>
                  </a:lnTo>
                  <a:lnTo>
                    <a:pt x="269" y="987"/>
                  </a:lnTo>
                  <a:lnTo>
                    <a:pt x="294" y="1073"/>
                  </a:lnTo>
                  <a:lnTo>
                    <a:pt x="322" y="1155"/>
                  </a:lnTo>
                  <a:lnTo>
                    <a:pt x="342" y="1219"/>
                  </a:lnTo>
                  <a:lnTo>
                    <a:pt x="363" y="1282"/>
                  </a:lnTo>
                  <a:lnTo>
                    <a:pt x="385" y="1324"/>
                  </a:lnTo>
                  <a:lnTo>
                    <a:pt x="405" y="136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6521400" y="1417680"/>
              <a:ext cx="158760" cy="436680"/>
            </a:xfrm>
            <a:custGeom>
              <a:avLst/>
              <a:gdLst/>
              <a:ahLst/>
              <a:rect l="l" t="t" r="r" b="b"/>
              <a:pathLst>
                <a:path w="201" h="549">
                  <a:moveTo>
                    <a:pt x="0" y="522"/>
                  </a:moveTo>
                  <a:lnTo>
                    <a:pt x="17" y="541"/>
                  </a:lnTo>
                  <a:lnTo>
                    <a:pt x="37" y="549"/>
                  </a:lnTo>
                  <a:lnTo>
                    <a:pt x="55" y="541"/>
                  </a:lnTo>
                  <a:lnTo>
                    <a:pt x="65" y="522"/>
                  </a:lnTo>
                  <a:lnTo>
                    <a:pt x="79" y="499"/>
                  </a:lnTo>
                  <a:lnTo>
                    <a:pt x="90" y="466"/>
                  </a:lnTo>
                  <a:lnTo>
                    <a:pt x="101" y="424"/>
                  </a:lnTo>
                  <a:lnTo>
                    <a:pt x="111" y="380"/>
                  </a:lnTo>
                  <a:lnTo>
                    <a:pt x="132" y="276"/>
                  </a:lnTo>
                  <a:lnTo>
                    <a:pt x="154" y="176"/>
                  </a:lnTo>
                  <a:lnTo>
                    <a:pt x="179" y="76"/>
                  </a:lnTo>
                  <a:lnTo>
                    <a:pt x="190" y="36"/>
                  </a:lnTo>
                  <a:lnTo>
                    <a:pt x="201" y="0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3474360" y="19479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3474360" y="17715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3474360" y="15922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3474360" y="14130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3474360" y="12351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3474360" y="10605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3474360" y="8827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3474360" y="7034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3563640" y="523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3503160" y="345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605040" y="63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4888080" y="6303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615780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648000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6654960" y="63036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3449520" y="2700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4595760" y="73080"/>
              <a:ext cx="12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thylene recep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3587760" y="418320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587760" y="364644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3587760" y="338472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3587760" y="3117960"/>
              <a:ext cx="3146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3587760" y="284940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3587760" y="258120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3587760" y="2581200"/>
              <a:ext cx="3146400" cy="160200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3587760" y="2581200"/>
              <a:ext cx="1440" cy="1602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3571920" y="418320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3571920" y="391464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571920" y="364644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571920" y="338472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3571920" y="31179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3571920" y="28494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3571920" y="25812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3587760" y="391464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V="1">
              <a:off x="358776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 flipV="1">
              <a:off x="4890960" y="3914280"/>
              <a:ext cx="180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 flipV="1">
              <a:off x="619128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flipV="1">
              <a:off x="651672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 flipV="1">
              <a:off x="6715080" y="3914280"/>
              <a:ext cx="180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flipV="1">
              <a:off x="673416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3587760" y="3736800"/>
              <a:ext cx="1357200" cy="177840"/>
            </a:xfrm>
            <a:custGeom>
              <a:avLst/>
              <a:gdLst/>
              <a:ahLst/>
              <a:rect l="l" t="t" r="r" b="b"/>
              <a:pathLst>
                <a:path w="1711" h="225">
                  <a:moveTo>
                    <a:pt x="0" y="225"/>
                  </a:moveTo>
                  <a:lnTo>
                    <a:pt x="215" y="204"/>
                  </a:lnTo>
                  <a:lnTo>
                    <a:pt x="432" y="182"/>
                  </a:lnTo>
                  <a:lnTo>
                    <a:pt x="862" y="148"/>
                  </a:lnTo>
                  <a:lnTo>
                    <a:pt x="1079" y="127"/>
                  </a:lnTo>
                  <a:lnTo>
                    <a:pt x="1295" y="98"/>
                  </a:lnTo>
                  <a:lnTo>
                    <a:pt x="1506" y="56"/>
                  </a:lnTo>
                  <a:lnTo>
                    <a:pt x="171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4944960" y="3094200"/>
              <a:ext cx="1246320" cy="642600"/>
            </a:xfrm>
            <a:custGeom>
              <a:avLst/>
              <a:gdLst/>
              <a:ahLst/>
              <a:rect l="l" t="t" r="r" b="b"/>
              <a:pathLst>
                <a:path w="1569" h="810">
                  <a:moveTo>
                    <a:pt x="0" y="810"/>
                  </a:moveTo>
                  <a:lnTo>
                    <a:pt x="105" y="774"/>
                  </a:lnTo>
                  <a:lnTo>
                    <a:pt x="211" y="731"/>
                  </a:lnTo>
                  <a:lnTo>
                    <a:pt x="432" y="641"/>
                  </a:lnTo>
                  <a:lnTo>
                    <a:pt x="647" y="534"/>
                  </a:lnTo>
                  <a:lnTo>
                    <a:pt x="863" y="423"/>
                  </a:lnTo>
                  <a:lnTo>
                    <a:pt x="969" y="359"/>
                  </a:lnTo>
                  <a:lnTo>
                    <a:pt x="1074" y="304"/>
                  </a:lnTo>
                  <a:lnTo>
                    <a:pt x="1169" y="246"/>
                  </a:lnTo>
                  <a:lnTo>
                    <a:pt x="1263" y="190"/>
                  </a:lnTo>
                  <a:lnTo>
                    <a:pt x="1347" y="140"/>
                  </a:lnTo>
                  <a:lnTo>
                    <a:pt x="1427" y="92"/>
                  </a:lnTo>
                  <a:lnTo>
                    <a:pt x="1502" y="43"/>
                  </a:lnTo>
                  <a:lnTo>
                    <a:pt x="156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6191280" y="2732040"/>
              <a:ext cx="325440" cy="362160"/>
            </a:xfrm>
            <a:custGeom>
              <a:avLst/>
              <a:gdLst/>
              <a:ahLst/>
              <a:rect l="l" t="t" r="r" b="b"/>
              <a:pathLst>
                <a:path w="411" h="456">
                  <a:moveTo>
                    <a:pt x="0" y="456"/>
                  </a:moveTo>
                  <a:lnTo>
                    <a:pt x="85" y="393"/>
                  </a:lnTo>
                  <a:lnTo>
                    <a:pt x="152" y="330"/>
                  </a:lnTo>
                  <a:lnTo>
                    <a:pt x="217" y="259"/>
                  </a:lnTo>
                  <a:lnTo>
                    <a:pt x="269" y="197"/>
                  </a:lnTo>
                  <a:lnTo>
                    <a:pt x="310" y="132"/>
                  </a:lnTo>
                  <a:lnTo>
                    <a:pt x="348" y="76"/>
                  </a:lnTo>
                  <a:lnTo>
                    <a:pt x="379" y="34"/>
                  </a:lnTo>
                  <a:lnTo>
                    <a:pt x="41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6516720" y="2646360"/>
              <a:ext cx="163440" cy="85680"/>
            </a:xfrm>
            <a:custGeom>
              <a:avLst/>
              <a:gdLst/>
              <a:ahLst/>
              <a:rect l="l" t="t" r="r" b="b"/>
              <a:pathLst>
                <a:path w="205" h="108">
                  <a:moveTo>
                    <a:pt x="0" y="108"/>
                  </a:moveTo>
                  <a:lnTo>
                    <a:pt x="31" y="79"/>
                  </a:lnTo>
                  <a:lnTo>
                    <a:pt x="63" y="58"/>
                  </a:lnTo>
                  <a:lnTo>
                    <a:pt x="90" y="42"/>
                  </a:lnTo>
                  <a:lnTo>
                    <a:pt x="115" y="37"/>
                  </a:lnTo>
                  <a:lnTo>
                    <a:pt x="158" y="23"/>
                  </a:lnTo>
                  <a:lnTo>
                    <a:pt x="205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6191280" y="3094200"/>
              <a:ext cx="325440" cy="660240"/>
            </a:xfrm>
            <a:custGeom>
              <a:avLst/>
              <a:gdLst/>
              <a:ahLst/>
              <a:rect l="l" t="t" r="r" b="b"/>
              <a:pathLst>
                <a:path w="411" h="831">
                  <a:moveTo>
                    <a:pt x="0" y="0"/>
                  </a:moveTo>
                  <a:lnTo>
                    <a:pt x="52" y="106"/>
                  </a:lnTo>
                  <a:lnTo>
                    <a:pt x="106" y="219"/>
                  </a:lnTo>
                  <a:lnTo>
                    <a:pt x="217" y="451"/>
                  </a:lnTo>
                  <a:lnTo>
                    <a:pt x="273" y="565"/>
                  </a:lnTo>
                  <a:lnTo>
                    <a:pt x="322" y="662"/>
                  </a:lnTo>
                  <a:lnTo>
                    <a:pt x="369" y="755"/>
                  </a:lnTo>
                  <a:lnTo>
                    <a:pt x="411" y="83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6516720" y="3754440"/>
              <a:ext cx="163440" cy="206280"/>
            </a:xfrm>
            <a:custGeom>
              <a:avLst/>
              <a:gdLst/>
              <a:ahLst/>
              <a:rect l="l" t="t" r="r" b="b"/>
              <a:pathLst>
                <a:path w="205" h="261">
                  <a:moveTo>
                    <a:pt x="0" y="0"/>
                  </a:moveTo>
                  <a:lnTo>
                    <a:pt x="31" y="50"/>
                  </a:lnTo>
                  <a:lnTo>
                    <a:pt x="59" y="90"/>
                  </a:lnTo>
                  <a:lnTo>
                    <a:pt x="90" y="127"/>
                  </a:lnTo>
                  <a:lnTo>
                    <a:pt x="115" y="161"/>
                  </a:lnTo>
                  <a:lnTo>
                    <a:pt x="163" y="211"/>
                  </a:lnTo>
                  <a:lnTo>
                    <a:pt x="205" y="26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4785840" y="2293920"/>
              <a:ext cx="22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ux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4979160" y="2293920"/>
              <a:ext cx="74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epressed prote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3499920" y="414324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3519000" y="4143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3516120" y="3876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3516120" y="3608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3516120" y="3348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3516120" y="3078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3516120" y="2809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3516120" y="2541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3559320" y="3983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4862520" y="3983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614988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647712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665496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3587760" y="2581200"/>
              <a:ext cx="1440" cy="16020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3571920" y="418320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3571920" y="391464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3571920" y="364644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3571920" y="338472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3571920" y="31179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3571920" y="28494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3571920" y="2581200"/>
              <a:ext cx="158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3587760" y="3914640"/>
              <a:ext cx="314640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 flipV="1">
              <a:off x="358776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 flipV="1">
              <a:off x="4890960" y="3914280"/>
              <a:ext cx="180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 flipV="1">
              <a:off x="619128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 flipV="1">
              <a:off x="6516720" y="3914280"/>
              <a:ext cx="144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 flipV="1">
              <a:off x="6715080" y="3914280"/>
              <a:ext cx="1800" cy="24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3587760" y="3736800"/>
              <a:ext cx="1357200" cy="177840"/>
            </a:xfrm>
            <a:custGeom>
              <a:avLst/>
              <a:gdLst/>
              <a:ahLst/>
              <a:rect l="l" t="t" r="r" b="b"/>
              <a:pathLst>
                <a:path w="1711" h="225">
                  <a:moveTo>
                    <a:pt x="0" y="225"/>
                  </a:moveTo>
                  <a:lnTo>
                    <a:pt x="215" y="204"/>
                  </a:lnTo>
                  <a:lnTo>
                    <a:pt x="432" y="182"/>
                  </a:lnTo>
                  <a:lnTo>
                    <a:pt x="862" y="148"/>
                  </a:lnTo>
                  <a:lnTo>
                    <a:pt x="1079" y="127"/>
                  </a:lnTo>
                  <a:lnTo>
                    <a:pt x="1295" y="98"/>
                  </a:lnTo>
                  <a:lnTo>
                    <a:pt x="1506" y="56"/>
                  </a:lnTo>
                  <a:lnTo>
                    <a:pt x="171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4944960" y="3094200"/>
              <a:ext cx="1246320" cy="642600"/>
            </a:xfrm>
            <a:custGeom>
              <a:avLst/>
              <a:gdLst/>
              <a:ahLst/>
              <a:rect l="l" t="t" r="r" b="b"/>
              <a:pathLst>
                <a:path w="1569" h="810">
                  <a:moveTo>
                    <a:pt x="0" y="810"/>
                  </a:moveTo>
                  <a:lnTo>
                    <a:pt x="105" y="774"/>
                  </a:lnTo>
                  <a:lnTo>
                    <a:pt x="211" y="731"/>
                  </a:lnTo>
                  <a:lnTo>
                    <a:pt x="432" y="641"/>
                  </a:lnTo>
                  <a:lnTo>
                    <a:pt x="647" y="534"/>
                  </a:lnTo>
                  <a:lnTo>
                    <a:pt x="863" y="423"/>
                  </a:lnTo>
                  <a:lnTo>
                    <a:pt x="969" y="359"/>
                  </a:lnTo>
                  <a:lnTo>
                    <a:pt x="1074" y="304"/>
                  </a:lnTo>
                  <a:lnTo>
                    <a:pt x="1169" y="246"/>
                  </a:lnTo>
                  <a:lnTo>
                    <a:pt x="1263" y="190"/>
                  </a:lnTo>
                  <a:lnTo>
                    <a:pt x="1347" y="140"/>
                  </a:lnTo>
                  <a:lnTo>
                    <a:pt x="1427" y="92"/>
                  </a:lnTo>
                  <a:lnTo>
                    <a:pt x="1502" y="43"/>
                  </a:lnTo>
                  <a:lnTo>
                    <a:pt x="156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6191280" y="2732040"/>
              <a:ext cx="325440" cy="362160"/>
            </a:xfrm>
            <a:custGeom>
              <a:avLst/>
              <a:gdLst/>
              <a:ahLst/>
              <a:rect l="l" t="t" r="r" b="b"/>
              <a:pathLst>
                <a:path w="411" h="456">
                  <a:moveTo>
                    <a:pt x="0" y="456"/>
                  </a:moveTo>
                  <a:lnTo>
                    <a:pt x="85" y="393"/>
                  </a:lnTo>
                  <a:lnTo>
                    <a:pt x="152" y="330"/>
                  </a:lnTo>
                  <a:lnTo>
                    <a:pt x="217" y="259"/>
                  </a:lnTo>
                  <a:lnTo>
                    <a:pt x="269" y="197"/>
                  </a:lnTo>
                  <a:lnTo>
                    <a:pt x="310" y="132"/>
                  </a:lnTo>
                  <a:lnTo>
                    <a:pt x="348" y="76"/>
                  </a:lnTo>
                  <a:lnTo>
                    <a:pt x="379" y="34"/>
                  </a:lnTo>
                  <a:lnTo>
                    <a:pt x="411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6516720" y="2646360"/>
              <a:ext cx="163440" cy="85680"/>
            </a:xfrm>
            <a:custGeom>
              <a:avLst/>
              <a:gdLst/>
              <a:ahLst/>
              <a:rect l="l" t="t" r="r" b="b"/>
              <a:pathLst>
                <a:path w="205" h="108">
                  <a:moveTo>
                    <a:pt x="0" y="108"/>
                  </a:moveTo>
                  <a:lnTo>
                    <a:pt x="31" y="79"/>
                  </a:lnTo>
                  <a:lnTo>
                    <a:pt x="63" y="58"/>
                  </a:lnTo>
                  <a:lnTo>
                    <a:pt x="90" y="42"/>
                  </a:lnTo>
                  <a:lnTo>
                    <a:pt x="115" y="37"/>
                  </a:lnTo>
                  <a:lnTo>
                    <a:pt x="158" y="23"/>
                  </a:lnTo>
                  <a:lnTo>
                    <a:pt x="205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6191280" y="3094200"/>
              <a:ext cx="325440" cy="660240"/>
            </a:xfrm>
            <a:custGeom>
              <a:avLst/>
              <a:gdLst/>
              <a:ahLst/>
              <a:rect l="l" t="t" r="r" b="b"/>
              <a:pathLst>
                <a:path w="411" h="831">
                  <a:moveTo>
                    <a:pt x="0" y="0"/>
                  </a:moveTo>
                  <a:lnTo>
                    <a:pt x="52" y="106"/>
                  </a:lnTo>
                  <a:lnTo>
                    <a:pt x="106" y="219"/>
                  </a:lnTo>
                  <a:lnTo>
                    <a:pt x="217" y="451"/>
                  </a:lnTo>
                  <a:lnTo>
                    <a:pt x="273" y="565"/>
                  </a:lnTo>
                  <a:lnTo>
                    <a:pt x="322" y="662"/>
                  </a:lnTo>
                  <a:lnTo>
                    <a:pt x="369" y="755"/>
                  </a:lnTo>
                  <a:lnTo>
                    <a:pt x="411" y="83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6516720" y="3754440"/>
              <a:ext cx="163440" cy="206280"/>
            </a:xfrm>
            <a:custGeom>
              <a:avLst/>
              <a:gdLst/>
              <a:ahLst/>
              <a:rect l="l" t="t" r="r" b="b"/>
              <a:pathLst>
                <a:path w="205" h="261">
                  <a:moveTo>
                    <a:pt x="0" y="0"/>
                  </a:moveTo>
                  <a:lnTo>
                    <a:pt x="31" y="50"/>
                  </a:lnTo>
                  <a:lnTo>
                    <a:pt x="59" y="90"/>
                  </a:lnTo>
                  <a:lnTo>
                    <a:pt x="90" y="127"/>
                  </a:lnTo>
                  <a:lnTo>
                    <a:pt x="115" y="161"/>
                  </a:lnTo>
                  <a:lnTo>
                    <a:pt x="163" y="211"/>
                  </a:lnTo>
                  <a:lnTo>
                    <a:pt x="205" y="261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3499920" y="4143240"/>
              <a:ext cx="26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3519000" y="4143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3516120" y="3876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3516120" y="3608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3516120" y="3348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3516120" y="3078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3516120" y="2809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3516120" y="2541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3559320" y="3983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4862520" y="3983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614988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647712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6654960" y="398304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3449520" y="2222640"/>
              <a:ext cx="3373560" cy="207792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4366800" y="2263680"/>
              <a:ext cx="161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uxin repressed prote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3449520" y="4383000"/>
              <a:ext cx="3373560" cy="207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449520" y="4383000"/>
              <a:ext cx="337356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3571920" y="598644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571920" y="5735520"/>
              <a:ext cx="31622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3571920" y="548964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3571920" y="523872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3571920" y="4991040"/>
              <a:ext cx="31622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3571920" y="474192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3571920" y="4741920"/>
              <a:ext cx="3162240" cy="149076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571920" y="4741920"/>
              <a:ext cx="1440" cy="149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3554280" y="623268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3554280" y="59864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3554280" y="57355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3554280" y="54896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3554280" y="5238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3554280" y="499104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3554280" y="4741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3571920" y="623268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flipV="1">
              <a:off x="357192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flipV="1">
              <a:off x="4879800" y="623232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flipV="1">
              <a:off x="618660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flipV="1">
              <a:off x="651672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 flipV="1">
              <a:off x="668664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 flipV="1">
              <a:off x="673416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3571920" y="6081840"/>
              <a:ext cx="1361880" cy="150840"/>
            </a:xfrm>
            <a:custGeom>
              <a:avLst/>
              <a:gdLst/>
              <a:ahLst/>
              <a:rect l="l" t="t" r="r" b="b"/>
              <a:pathLst>
                <a:path w="1716" h="190">
                  <a:moveTo>
                    <a:pt x="0" y="190"/>
                  </a:moveTo>
                  <a:lnTo>
                    <a:pt x="216" y="167"/>
                  </a:lnTo>
                  <a:lnTo>
                    <a:pt x="431" y="154"/>
                  </a:lnTo>
                  <a:lnTo>
                    <a:pt x="869" y="135"/>
                  </a:lnTo>
                  <a:lnTo>
                    <a:pt x="1084" y="119"/>
                  </a:lnTo>
                  <a:lnTo>
                    <a:pt x="1295" y="93"/>
                  </a:lnTo>
                  <a:lnTo>
                    <a:pt x="1507" y="56"/>
                  </a:lnTo>
                  <a:lnTo>
                    <a:pt x="1716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4933800" y="5410080"/>
              <a:ext cx="1252800" cy="671760"/>
            </a:xfrm>
            <a:custGeom>
              <a:avLst/>
              <a:gdLst/>
              <a:ahLst/>
              <a:rect l="l" t="t" r="r" b="b"/>
              <a:pathLst>
                <a:path w="1579" h="846">
                  <a:moveTo>
                    <a:pt x="0" y="846"/>
                  </a:moveTo>
                  <a:lnTo>
                    <a:pt x="105" y="810"/>
                  </a:lnTo>
                  <a:lnTo>
                    <a:pt x="210" y="768"/>
                  </a:lnTo>
                  <a:lnTo>
                    <a:pt x="431" y="670"/>
                  </a:lnTo>
                  <a:lnTo>
                    <a:pt x="653" y="564"/>
                  </a:lnTo>
                  <a:lnTo>
                    <a:pt x="869" y="445"/>
                  </a:lnTo>
                  <a:lnTo>
                    <a:pt x="975" y="382"/>
                  </a:lnTo>
                  <a:lnTo>
                    <a:pt x="1078" y="319"/>
                  </a:lnTo>
                  <a:lnTo>
                    <a:pt x="1175" y="263"/>
                  </a:lnTo>
                  <a:lnTo>
                    <a:pt x="1269" y="207"/>
                  </a:lnTo>
                  <a:lnTo>
                    <a:pt x="1358" y="148"/>
                  </a:lnTo>
                  <a:lnTo>
                    <a:pt x="1437" y="92"/>
                  </a:lnTo>
                  <a:lnTo>
                    <a:pt x="1512" y="44"/>
                  </a:lnTo>
                  <a:lnTo>
                    <a:pt x="157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6186600" y="5025960"/>
              <a:ext cx="330120" cy="384120"/>
            </a:xfrm>
            <a:custGeom>
              <a:avLst/>
              <a:gdLst/>
              <a:ahLst/>
              <a:rect l="l" t="t" r="r" b="b"/>
              <a:pathLst>
                <a:path w="417" h="484">
                  <a:moveTo>
                    <a:pt x="0" y="484"/>
                  </a:moveTo>
                  <a:lnTo>
                    <a:pt x="85" y="423"/>
                  </a:lnTo>
                  <a:lnTo>
                    <a:pt x="158" y="354"/>
                  </a:lnTo>
                  <a:lnTo>
                    <a:pt x="223" y="275"/>
                  </a:lnTo>
                  <a:lnTo>
                    <a:pt x="275" y="204"/>
                  </a:lnTo>
                  <a:lnTo>
                    <a:pt x="316" y="141"/>
                  </a:lnTo>
                  <a:lnTo>
                    <a:pt x="354" y="85"/>
                  </a:lnTo>
                  <a:lnTo>
                    <a:pt x="385" y="35"/>
                  </a:lnTo>
                  <a:lnTo>
                    <a:pt x="417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6516720" y="4979880"/>
              <a:ext cx="163440" cy="46080"/>
            </a:xfrm>
            <a:custGeom>
              <a:avLst/>
              <a:gdLst/>
              <a:ahLst/>
              <a:rect l="l" t="t" r="r" b="b"/>
              <a:pathLst>
                <a:path w="205" h="57">
                  <a:moveTo>
                    <a:pt x="0" y="57"/>
                  </a:moveTo>
                  <a:lnTo>
                    <a:pt x="31" y="36"/>
                  </a:lnTo>
                  <a:lnTo>
                    <a:pt x="63" y="13"/>
                  </a:lnTo>
                  <a:lnTo>
                    <a:pt x="90" y="8"/>
                  </a:lnTo>
                  <a:lnTo>
                    <a:pt x="115" y="8"/>
                  </a:lnTo>
                  <a:lnTo>
                    <a:pt x="163" y="8"/>
                  </a:lnTo>
                  <a:lnTo>
                    <a:pt x="205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6186600" y="5410080"/>
              <a:ext cx="330120" cy="480960"/>
            </a:xfrm>
            <a:custGeom>
              <a:avLst/>
              <a:gdLst/>
              <a:ahLst/>
              <a:rect l="l" t="t" r="r" b="b"/>
              <a:pathLst>
                <a:path w="417" h="607">
                  <a:moveTo>
                    <a:pt x="0" y="0"/>
                  </a:moveTo>
                  <a:lnTo>
                    <a:pt x="112" y="157"/>
                  </a:lnTo>
                  <a:lnTo>
                    <a:pt x="223" y="319"/>
                  </a:lnTo>
                  <a:lnTo>
                    <a:pt x="275" y="397"/>
                  </a:lnTo>
                  <a:lnTo>
                    <a:pt x="328" y="472"/>
                  </a:lnTo>
                  <a:lnTo>
                    <a:pt x="375" y="545"/>
                  </a:lnTo>
                  <a:lnTo>
                    <a:pt x="417" y="607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6516720" y="5891040"/>
              <a:ext cx="163440" cy="308160"/>
            </a:xfrm>
            <a:custGeom>
              <a:avLst/>
              <a:gdLst/>
              <a:ahLst/>
              <a:rect l="l" t="t" r="r" b="b"/>
              <a:pathLst>
                <a:path w="205" h="387">
                  <a:moveTo>
                    <a:pt x="0" y="0"/>
                  </a:moveTo>
                  <a:lnTo>
                    <a:pt x="37" y="55"/>
                  </a:lnTo>
                  <a:lnTo>
                    <a:pt x="69" y="113"/>
                  </a:lnTo>
                  <a:lnTo>
                    <a:pt x="94" y="161"/>
                  </a:lnTo>
                  <a:lnTo>
                    <a:pt x="115" y="203"/>
                  </a:lnTo>
                  <a:lnTo>
                    <a:pt x="158" y="295"/>
                  </a:lnTo>
                  <a:lnTo>
                    <a:pt x="205" y="387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5074560" y="4454640"/>
              <a:ext cx="17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ET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3500280" y="61945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3500280" y="5948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3500280" y="5699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3500280" y="54514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3500280" y="5199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3500280" y="4952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3500280" y="47023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3541680" y="6300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4849920" y="6300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614520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647712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664524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3449520" y="4383000"/>
              <a:ext cx="337356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3429000" y="4356000"/>
              <a:ext cx="3373560" cy="207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3449520" y="4383000"/>
              <a:ext cx="337356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3571920" y="4741920"/>
              <a:ext cx="1440" cy="1490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3554280" y="623268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3554280" y="59864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3554280" y="573552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3554280" y="548964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3554280" y="52387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3554280" y="4991040"/>
              <a:ext cx="1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3554280" y="4741920"/>
              <a:ext cx="1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3571920" y="6232680"/>
              <a:ext cx="31622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 flipV="1">
              <a:off x="357192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 flipV="1">
              <a:off x="4879800" y="623232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 flipV="1">
              <a:off x="618660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 flipV="1">
              <a:off x="651672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 flipV="1">
              <a:off x="6686640" y="623232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3571920" y="6081840"/>
              <a:ext cx="1361880" cy="150840"/>
            </a:xfrm>
            <a:custGeom>
              <a:avLst/>
              <a:gdLst/>
              <a:ahLst/>
              <a:rect l="l" t="t" r="r" b="b"/>
              <a:pathLst>
                <a:path w="1716" h="190">
                  <a:moveTo>
                    <a:pt x="0" y="190"/>
                  </a:moveTo>
                  <a:lnTo>
                    <a:pt x="216" y="167"/>
                  </a:lnTo>
                  <a:lnTo>
                    <a:pt x="431" y="154"/>
                  </a:lnTo>
                  <a:lnTo>
                    <a:pt x="869" y="135"/>
                  </a:lnTo>
                  <a:lnTo>
                    <a:pt x="1084" y="119"/>
                  </a:lnTo>
                  <a:lnTo>
                    <a:pt x="1295" y="93"/>
                  </a:lnTo>
                  <a:lnTo>
                    <a:pt x="1507" y="56"/>
                  </a:lnTo>
                  <a:lnTo>
                    <a:pt x="1716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4933800" y="5410080"/>
              <a:ext cx="1252800" cy="671760"/>
            </a:xfrm>
            <a:custGeom>
              <a:avLst/>
              <a:gdLst/>
              <a:ahLst/>
              <a:rect l="l" t="t" r="r" b="b"/>
              <a:pathLst>
                <a:path w="1579" h="846">
                  <a:moveTo>
                    <a:pt x="0" y="846"/>
                  </a:moveTo>
                  <a:lnTo>
                    <a:pt x="105" y="810"/>
                  </a:lnTo>
                  <a:lnTo>
                    <a:pt x="210" y="768"/>
                  </a:lnTo>
                  <a:lnTo>
                    <a:pt x="431" y="670"/>
                  </a:lnTo>
                  <a:lnTo>
                    <a:pt x="653" y="564"/>
                  </a:lnTo>
                  <a:lnTo>
                    <a:pt x="869" y="445"/>
                  </a:lnTo>
                  <a:lnTo>
                    <a:pt x="975" y="382"/>
                  </a:lnTo>
                  <a:lnTo>
                    <a:pt x="1078" y="319"/>
                  </a:lnTo>
                  <a:lnTo>
                    <a:pt x="1175" y="263"/>
                  </a:lnTo>
                  <a:lnTo>
                    <a:pt x="1269" y="207"/>
                  </a:lnTo>
                  <a:lnTo>
                    <a:pt x="1358" y="148"/>
                  </a:lnTo>
                  <a:lnTo>
                    <a:pt x="1437" y="92"/>
                  </a:lnTo>
                  <a:lnTo>
                    <a:pt x="1512" y="44"/>
                  </a:lnTo>
                  <a:lnTo>
                    <a:pt x="1579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6186600" y="5025960"/>
              <a:ext cx="330120" cy="384120"/>
            </a:xfrm>
            <a:custGeom>
              <a:avLst/>
              <a:gdLst/>
              <a:ahLst/>
              <a:rect l="l" t="t" r="r" b="b"/>
              <a:pathLst>
                <a:path w="417" h="484">
                  <a:moveTo>
                    <a:pt x="0" y="484"/>
                  </a:moveTo>
                  <a:lnTo>
                    <a:pt x="85" y="423"/>
                  </a:lnTo>
                  <a:lnTo>
                    <a:pt x="158" y="354"/>
                  </a:lnTo>
                  <a:lnTo>
                    <a:pt x="223" y="275"/>
                  </a:lnTo>
                  <a:lnTo>
                    <a:pt x="275" y="204"/>
                  </a:lnTo>
                  <a:lnTo>
                    <a:pt x="316" y="141"/>
                  </a:lnTo>
                  <a:lnTo>
                    <a:pt x="354" y="85"/>
                  </a:lnTo>
                  <a:lnTo>
                    <a:pt x="385" y="35"/>
                  </a:lnTo>
                  <a:lnTo>
                    <a:pt x="417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6516720" y="4979880"/>
              <a:ext cx="163440" cy="46080"/>
            </a:xfrm>
            <a:custGeom>
              <a:avLst/>
              <a:gdLst/>
              <a:ahLst/>
              <a:rect l="l" t="t" r="r" b="b"/>
              <a:pathLst>
                <a:path w="205" h="57">
                  <a:moveTo>
                    <a:pt x="0" y="57"/>
                  </a:moveTo>
                  <a:lnTo>
                    <a:pt x="31" y="36"/>
                  </a:lnTo>
                  <a:lnTo>
                    <a:pt x="63" y="13"/>
                  </a:lnTo>
                  <a:lnTo>
                    <a:pt x="90" y="8"/>
                  </a:lnTo>
                  <a:lnTo>
                    <a:pt x="115" y="8"/>
                  </a:lnTo>
                  <a:lnTo>
                    <a:pt x="163" y="8"/>
                  </a:lnTo>
                  <a:lnTo>
                    <a:pt x="205" y="0"/>
                  </a:lnTo>
                </a:path>
              </a:pathLst>
            </a:custGeom>
            <a:noFill/>
            <a:ln w="144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6186600" y="5410080"/>
              <a:ext cx="330120" cy="480960"/>
            </a:xfrm>
            <a:custGeom>
              <a:avLst/>
              <a:gdLst/>
              <a:ahLst/>
              <a:rect l="l" t="t" r="r" b="b"/>
              <a:pathLst>
                <a:path w="417" h="607">
                  <a:moveTo>
                    <a:pt x="0" y="0"/>
                  </a:moveTo>
                  <a:lnTo>
                    <a:pt x="112" y="157"/>
                  </a:lnTo>
                  <a:lnTo>
                    <a:pt x="223" y="319"/>
                  </a:lnTo>
                  <a:lnTo>
                    <a:pt x="275" y="397"/>
                  </a:lnTo>
                  <a:lnTo>
                    <a:pt x="328" y="472"/>
                  </a:lnTo>
                  <a:lnTo>
                    <a:pt x="375" y="545"/>
                  </a:lnTo>
                  <a:lnTo>
                    <a:pt x="417" y="607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6516720" y="5891040"/>
              <a:ext cx="163440" cy="308160"/>
            </a:xfrm>
            <a:custGeom>
              <a:avLst/>
              <a:gdLst/>
              <a:ahLst/>
              <a:rect l="l" t="t" r="r" b="b"/>
              <a:pathLst>
                <a:path w="205" h="387">
                  <a:moveTo>
                    <a:pt x="0" y="0"/>
                  </a:moveTo>
                  <a:lnTo>
                    <a:pt x="37" y="55"/>
                  </a:lnTo>
                  <a:lnTo>
                    <a:pt x="69" y="113"/>
                  </a:lnTo>
                  <a:lnTo>
                    <a:pt x="94" y="161"/>
                  </a:lnTo>
                  <a:lnTo>
                    <a:pt x="115" y="203"/>
                  </a:lnTo>
                  <a:lnTo>
                    <a:pt x="158" y="295"/>
                  </a:lnTo>
                  <a:lnTo>
                    <a:pt x="205" y="387"/>
                  </a:lnTo>
                </a:path>
              </a:pathLst>
            </a:custGeom>
            <a:noFill/>
            <a:ln w="144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5075280" y="445464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T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3500280" y="61945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3500280" y="5948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3500280" y="5699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3500280" y="54514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3500280" y="5199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3500280" y="4952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3500280" y="47023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3541680" y="6300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4849920" y="6300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614520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647712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6645240" y="6300720"/>
              <a:ext cx="128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449520" y="4383000"/>
              <a:ext cx="3373560" cy="2078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4T07:47:59Z</dcterms:created>
  <dc:creator>costaf</dc:creator>
  <dc:description/>
  <dc:language>en-US</dc:language>
  <cp:lastModifiedBy>costaf</cp:lastModifiedBy>
  <dcterms:modified xsi:type="dcterms:W3CDTF">2010-10-01T07:44:11Z</dcterms:modified>
  <cp:revision>3</cp:revision>
  <dc:subject/>
  <dc:title>Diapositiva 1</dc:title>
</cp:coreProperties>
</file>